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embeddings/oleObject4.bin" ContentType="application/vnd.openxmlformats-officedocument.oleObject"/>
  <Override PartName="/ppt/embeddings/oleObject5.bin" ContentType="application/vnd.openxmlformats-officedocument.oleObject"/>
  <Override PartName="/ppt/embeddings/oleObject6.bin" ContentType="application/vnd.openxmlformats-officedocument.oleObject"/>
  <Override PartName="/ppt/embeddings/oleObject7.bin" ContentType="application/vnd.openxmlformats-officedocument.oleObject"/>
  <Override PartName="/ppt/embeddings/oleObject8.bin" ContentType="application/vnd.openxmlformats-officedocument.oleObject"/>
  <Override PartName="/ppt/embeddings/oleObject9.bin" ContentType="application/vnd.openxmlformats-officedocument.oleObject"/>
  <Override PartName="/ppt/media/image27.png" ContentType="image/png"/>
  <Override PartName="/ppt/media/image33.jpeg" ContentType="image/jpeg"/>
  <Override PartName="/ppt/media/image23.png" ContentType="image/png"/>
  <Override PartName="/ppt/media/image22.png" ContentType="image/png"/>
  <Override PartName="/ppt/media/image21.png" ContentType="image/png"/>
  <Override PartName="/ppt/media/image19.png" ContentType="image/png"/>
  <Override PartName="/ppt/media/image17.png" ContentType="image/png"/>
  <Override PartName="/ppt/media/image32.jpeg" ContentType="image/jpeg"/>
  <Override PartName="/ppt/media/image16.png" ContentType="image/png"/>
  <Override PartName="/ppt/media/image15.jpeg" ContentType="image/jpeg"/>
  <Override PartName="/ppt/media/image14.jpeg" ContentType="image/jpeg"/>
  <Override PartName="/ppt/media/image24.png" ContentType="image/png"/>
  <Override PartName="/ppt/media/image11.jpeg" ContentType="image/jpeg"/>
  <Override PartName="/ppt/media/image1.png" ContentType="image/png"/>
  <Override PartName="/ppt/media/image31.png" ContentType="image/png"/>
  <Override PartName="/ppt/media/image26.png" ContentType="image/png"/>
  <Override PartName="/ppt/media/image3.png" ContentType="image/png"/>
  <Override PartName="/ppt/media/image25.png" ContentType="image/png"/>
  <Override PartName="/ppt/media/image2.png" ContentType="image/png"/>
  <Override PartName="/ppt/media/image4.jpeg" ContentType="image/jpeg"/>
  <Override PartName="/ppt/media/image40.png" ContentType="image/png"/>
  <Override PartName="/ppt/media/image39.png" ContentType="image/png"/>
  <Override PartName="/ppt/media/image41.png" ContentType="image/png"/>
  <Override PartName="/ppt/media/image30.png" ContentType="image/png"/>
  <Override PartName="/ppt/media/image37.jpeg" ContentType="image/jpeg"/>
  <Override PartName="/ppt/media/image13.png" ContentType="image/png"/>
  <Override PartName="/ppt/media/image42.png" ContentType="image/png"/>
  <Override PartName="/ppt/media/image12.png" ContentType="image/png"/>
  <Override PartName="/ppt/media/image49.png" ContentType="image/png"/>
  <Override PartName="/ppt/media/image44.jpeg" ContentType="image/jpeg"/>
  <Override PartName="/ppt/media/image34.png" ContentType="image/png"/>
  <Override PartName="/ppt/media/image43.jpeg" ContentType="image/jpeg"/>
  <Override PartName="/ppt/media/image35.png" ContentType="image/png"/>
  <Override PartName="/ppt/media/image50.png" ContentType="image/png"/>
  <Override PartName="/ppt/media/image5.jpeg" ContentType="image/jpeg"/>
  <Override PartName="/ppt/media/image45.jpeg" ContentType="image/jpeg"/>
  <Override PartName="/ppt/media/image46.png" ContentType="image/png"/>
  <Override PartName="/ppt/media/image48.png" ContentType="image/png"/>
  <Override PartName="/ppt/media/image9.jpeg" ContentType="image/jpeg"/>
  <Override PartName="/ppt/media/image8.jpeg" ContentType="image/jpeg"/>
  <Override PartName="/ppt/media/image38.png" ContentType="image/png"/>
  <Override PartName="/ppt/media/image47.png" ContentType="image/png"/>
  <Override PartName="/ppt/media/image10.png" ContentType="image/png"/>
  <Override PartName="/ppt/media/image28.png" ContentType="image/png"/>
  <Override PartName="/ppt/media/image7.jpeg" ContentType="image/jpeg"/>
  <Override PartName="/ppt/media/image18.png" ContentType="image/png"/>
  <Override PartName="/ppt/media/image36.jpeg" ContentType="image/jpeg"/>
  <Override PartName="/ppt/media/image20.png" ContentType="image/png"/>
  <Override PartName="/ppt/media/image6.png" ContentType="image/png"/>
  <Override PartName="/ppt/media/image29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6858000" cy="9907588"/>
  <p:notesSz cx="7105650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4FD960-665A-4F1B-A81E-BAAEA1A8F2F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DB7955-1191-4334-91A3-611040EE397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B938B2-03C1-49A2-B263-9E7D2380116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876567-D742-4566-AD26-DB00F0F4E6E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D8B116-7D75-482F-8414-CDB449527DF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97437E-E742-47D4-BB8B-03DB3418A62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E450EB-6429-4F5E-80F5-778E72374C1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C5CCF9-F811-45CD-9035-A305CD1A10C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BF8C3C-C392-460A-AAED-58CB6D5FEC5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8E147B-D6D4-4311-8E58-C489D7F8A27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1C1839-139C-4B16-AD8C-CF0062F17F5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9E2735-4076-44D3-9DC1-FB9D7F69831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0160"/>
            <a:ext cx="217152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A49F254-CB95-4310-B420-08474E2C7694}" type="slidenum">
              <a:rPr b="0" lang="de-DE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png"/><Relationship Id="rId3" Type="http://schemas.openxmlformats.org/officeDocument/2006/relationships/oleObject" Target="../embeddings/oleObject2.bin"/><Relationship Id="rId4" Type="http://schemas.openxmlformats.org/officeDocument/2006/relationships/image" Target="../media/image2.png"/><Relationship Id="rId5" Type="http://schemas.openxmlformats.org/officeDocument/2006/relationships/oleObject" Target="../embeddings/oleObject3.bin"/><Relationship Id="rId6" Type="http://schemas.openxmlformats.org/officeDocument/2006/relationships/image" Target="../media/image3.png"/><Relationship Id="rId7" Type="http://schemas.openxmlformats.org/officeDocument/2006/relationships/image" Target="../media/image4.jpeg"/><Relationship Id="rId8" Type="http://schemas.openxmlformats.org/officeDocument/2006/relationships/image" Target="../media/image5.jpeg"/><Relationship Id="rId9" Type="http://schemas.openxmlformats.org/officeDocument/2006/relationships/image" Target="../media/image6.png"/><Relationship Id="rId10" Type="http://schemas.openxmlformats.org/officeDocument/2006/relationships/image" Target="../media/image7.jpeg"/><Relationship Id="rId11" Type="http://schemas.openxmlformats.org/officeDocument/2006/relationships/image" Target="../media/image8.jpeg"/><Relationship Id="rId12" Type="http://schemas.openxmlformats.org/officeDocument/2006/relationships/image" Target="../media/image9.jpeg"/><Relationship Id="rId13" Type="http://schemas.openxmlformats.org/officeDocument/2006/relationships/image" Target="../media/image10.png"/><Relationship Id="rId14" Type="http://schemas.openxmlformats.org/officeDocument/2006/relationships/image" Target="../media/image11.jpeg"/><Relationship Id="rId15" Type="http://schemas.openxmlformats.org/officeDocument/2006/relationships/image" Target="../media/image12.png"/><Relationship Id="rId16" Type="http://schemas.openxmlformats.org/officeDocument/2006/relationships/image" Target="../media/image13.png"/><Relationship Id="rId17" Type="http://schemas.openxmlformats.org/officeDocument/2006/relationships/image" Target="../media/image14.jpeg"/><Relationship Id="rId18" Type="http://schemas.openxmlformats.org/officeDocument/2006/relationships/image" Target="../media/image15.jpeg"/><Relationship Id="rId19" Type="http://schemas.openxmlformats.org/officeDocument/2006/relationships/image" Target="../media/image16.png"/><Relationship Id="rId20" Type="http://schemas.openxmlformats.org/officeDocument/2006/relationships/image" Target="../media/image17.png"/><Relationship Id="rId21" Type="http://schemas.openxmlformats.org/officeDocument/2006/relationships/image" Target="../media/image18.png"/><Relationship Id="rId22" Type="http://schemas.openxmlformats.org/officeDocument/2006/relationships/image" Target="../media/image19.png"/><Relationship Id="rId23" Type="http://schemas.openxmlformats.org/officeDocument/2006/relationships/image" Target="../media/image20.png"/><Relationship Id="rId24" Type="http://schemas.openxmlformats.org/officeDocument/2006/relationships/image" Target="../media/image21.png"/><Relationship Id="rId25" Type="http://schemas.openxmlformats.org/officeDocument/2006/relationships/image" Target="../media/image22.png"/><Relationship Id="rId26" Type="http://schemas.openxmlformats.org/officeDocument/2006/relationships/image" Target="../media/image23.png"/><Relationship Id="rId27" Type="http://schemas.openxmlformats.org/officeDocument/2006/relationships/oleObject" Target="../embeddings/oleObject4.bin"/><Relationship Id="rId28" Type="http://schemas.openxmlformats.org/officeDocument/2006/relationships/image" Target="../media/image24.png"/><Relationship Id="rId29" Type="http://schemas.openxmlformats.org/officeDocument/2006/relationships/oleObject" Target="../embeddings/oleObject5.bin"/><Relationship Id="rId30" Type="http://schemas.openxmlformats.org/officeDocument/2006/relationships/image" Target="../media/image25.png"/><Relationship Id="rId31" Type="http://schemas.openxmlformats.org/officeDocument/2006/relationships/image" Target="../media/image26.png"/><Relationship Id="rId32" Type="http://schemas.openxmlformats.org/officeDocument/2006/relationships/image" Target="../media/image27.png"/><Relationship Id="rId33" Type="http://schemas.openxmlformats.org/officeDocument/2006/relationships/image" Target="../media/image28.png"/><Relationship Id="rId34" Type="http://schemas.openxmlformats.org/officeDocument/2006/relationships/image" Target="../media/image29.png"/><Relationship Id="rId35" Type="http://schemas.openxmlformats.org/officeDocument/2006/relationships/image" Target="../media/image30.png"/><Relationship Id="rId36" Type="http://schemas.openxmlformats.org/officeDocument/2006/relationships/image" Target="../media/image31.png"/><Relationship Id="rId37" Type="http://schemas.openxmlformats.org/officeDocument/2006/relationships/image" Target="../media/image32.jpeg"/><Relationship Id="rId38" Type="http://schemas.openxmlformats.org/officeDocument/2006/relationships/image" Target="../media/image33.jpeg"/><Relationship Id="rId39" Type="http://schemas.openxmlformats.org/officeDocument/2006/relationships/image" Target="../media/image34.png"/><Relationship Id="rId40" Type="http://schemas.openxmlformats.org/officeDocument/2006/relationships/oleObject" Target="../embeddings/oleObject6.bin"/><Relationship Id="rId41" Type="http://schemas.openxmlformats.org/officeDocument/2006/relationships/image" Target="../media/image35.png"/><Relationship Id="rId42" Type="http://schemas.openxmlformats.org/officeDocument/2006/relationships/image" Target="../media/image36.jpeg"/><Relationship Id="rId43" Type="http://schemas.openxmlformats.org/officeDocument/2006/relationships/image" Target="../media/image37.jpeg"/><Relationship Id="rId44" Type="http://schemas.openxmlformats.org/officeDocument/2006/relationships/image" Target="../media/image38.png"/><Relationship Id="rId45" Type="http://schemas.openxmlformats.org/officeDocument/2006/relationships/image" Target="../media/image39.png"/><Relationship Id="rId46" Type="http://schemas.openxmlformats.org/officeDocument/2006/relationships/oleObject" Target="../embeddings/oleObject7.bin"/><Relationship Id="rId47" Type="http://schemas.openxmlformats.org/officeDocument/2006/relationships/image" Target="../media/image40.png"/><Relationship Id="rId48" Type="http://schemas.openxmlformats.org/officeDocument/2006/relationships/oleObject" Target="../embeddings/oleObject8.bin"/><Relationship Id="rId49" Type="http://schemas.openxmlformats.org/officeDocument/2006/relationships/image" Target="../media/image41.png"/><Relationship Id="rId50" Type="http://schemas.openxmlformats.org/officeDocument/2006/relationships/oleObject" Target="../embeddings/oleObject9.bin"/><Relationship Id="rId51" Type="http://schemas.openxmlformats.org/officeDocument/2006/relationships/image" Target="../media/image42.png"/><Relationship Id="rId52" Type="http://schemas.openxmlformats.org/officeDocument/2006/relationships/image" Target="../media/image43.jpeg"/><Relationship Id="rId53" Type="http://schemas.openxmlformats.org/officeDocument/2006/relationships/image" Target="../media/image43.jpeg"/><Relationship Id="rId54" Type="http://schemas.openxmlformats.org/officeDocument/2006/relationships/image" Target="../media/image44.jpeg"/><Relationship Id="rId55" Type="http://schemas.openxmlformats.org/officeDocument/2006/relationships/image" Target="../media/image44.jpeg"/><Relationship Id="rId56" Type="http://schemas.openxmlformats.org/officeDocument/2006/relationships/image" Target="../media/image45.jpeg"/><Relationship Id="rId57" Type="http://schemas.openxmlformats.org/officeDocument/2006/relationships/image" Target="../media/image45.jpeg"/><Relationship Id="rId58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46.png"/><Relationship Id="rId2" Type="http://schemas.openxmlformats.org/officeDocument/2006/relationships/oleObject" Target="../embeddings/oleObject1.bin"/><Relationship Id="rId3" Type="http://schemas.openxmlformats.org/officeDocument/2006/relationships/image" Target="../media/image47.png"/><Relationship Id="rId4" Type="http://schemas.openxmlformats.org/officeDocument/2006/relationships/oleObject" Target="../embeddings/oleObject2.bin"/><Relationship Id="rId5" Type="http://schemas.openxmlformats.org/officeDocument/2006/relationships/image" Target="../media/image48.png"/><Relationship Id="rId6" Type="http://schemas.openxmlformats.org/officeDocument/2006/relationships/oleObject" Target="../embeddings/oleObject3.bin"/><Relationship Id="rId7" Type="http://schemas.openxmlformats.org/officeDocument/2006/relationships/image" Target="../media/image49.png"/><Relationship Id="rId8" Type="http://schemas.openxmlformats.org/officeDocument/2006/relationships/oleObject" Target="../embeddings/oleObject4.bin"/><Relationship Id="rId9" Type="http://schemas.openxmlformats.org/officeDocument/2006/relationships/image" Target="../media/image50.png"/><Relationship Id="rId10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Object 179"/>
          <p:cNvGraphicFramePr/>
          <p:nvPr/>
        </p:nvGraphicFramePr>
        <p:xfrm>
          <a:off x="3008160" y="3451320"/>
          <a:ext cx="928800" cy="17928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2" name="Object 179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3008160" y="3451320"/>
                    <a:ext cx="928800" cy="1792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43" name="Object 178"/>
          <p:cNvGraphicFramePr/>
          <p:nvPr/>
        </p:nvGraphicFramePr>
        <p:xfrm>
          <a:off x="984240" y="1668600"/>
          <a:ext cx="909720" cy="16020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44" name="Object 178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984240" y="1668600"/>
                    <a:ext cx="909720" cy="1602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45" name="Object 177"/>
          <p:cNvGraphicFramePr/>
          <p:nvPr/>
        </p:nvGraphicFramePr>
        <p:xfrm>
          <a:off x="5191200" y="3206880"/>
          <a:ext cx="925560" cy="177840"/>
        </p:xfrm>
        <a:graphic>
          <a:graphicData uri="http://schemas.openxmlformats.org/presentationml/2006/ole">
            <p:oleObj r:id="rId5" spid="">
              <p:embed/>
              <p:pic>
                <p:nvPicPr>
                  <p:cNvPr id="46" name="Object 177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5191200" y="3206880"/>
                    <a:ext cx="925560" cy="1778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pic>
        <p:nvPicPr>
          <p:cNvPr id="47" name="Grafik 197" descr="Bild1.jpg"/>
          <p:cNvPicPr/>
          <p:nvPr/>
        </p:nvPicPr>
        <p:blipFill>
          <a:blip r:embed="rId7"/>
          <a:srcRect l="0" t="0" r="23461" b="0"/>
          <a:stretch/>
        </p:blipFill>
        <p:spPr>
          <a:xfrm>
            <a:off x="963720" y="4802040"/>
            <a:ext cx="936360" cy="179640"/>
          </a:xfrm>
          <a:prstGeom prst="rect">
            <a:avLst/>
          </a:prstGeom>
          <a:ln w="0">
            <a:noFill/>
          </a:ln>
        </p:spPr>
      </p:pic>
      <p:pic>
        <p:nvPicPr>
          <p:cNvPr id="48" name="Grafik 198" descr="Bild2.jpg"/>
          <p:cNvPicPr/>
          <p:nvPr/>
        </p:nvPicPr>
        <p:blipFill>
          <a:blip r:embed="rId8"/>
          <a:srcRect l="0" t="0" r="28592" b="0"/>
          <a:stretch/>
        </p:blipFill>
        <p:spPr>
          <a:xfrm>
            <a:off x="963720" y="5038560"/>
            <a:ext cx="934920" cy="179640"/>
          </a:xfrm>
          <a:prstGeom prst="rect">
            <a:avLst/>
          </a:prstGeom>
          <a:ln w="0">
            <a:noFill/>
          </a:ln>
        </p:spPr>
      </p:pic>
      <p:pic>
        <p:nvPicPr>
          <p:cNvPr id="49" name="Picture 193" descr=""/>
          <p:cNvPicPr/>
          <p:nvPr/>
        </p:nvPicPr>
        <p:blipFill>
          <a:blip r:embed="rId9"/>
          <a:stretch/>
        </p:blipFill>
        <p:spPr>
          <a:xfrm>
            <a:off x="3019320" y="5619600"/>
            <a:ext cx="936720" cy="179640"/>
          </a:xfrm>
          <a:prstGeom prst="rect">
            <a:avLst/>
          </a:prstGeom>
          <a:ln w="0">
            <a:noFill/>
          </a:ln>
        </p:spPr>
      </p:pic>
      <p:pic>
        <p:nvPicPr>
          <p:cNvPr id="50" name="Picture 192" descr="H:\Paper BA\Harald 110906\scans 202\110909Maus202_2sip53_GAPDH_1883.jpg"/>
          <p:cNvPicPr/>
          <p:nvPr/>
        </p:nvPicPr>
        <p:blipFill>
          <a:blip r:embed="rId10"/>
          <a:srcRect l="4452" t="25974" r="5183" b="31515"/>
          <a:stretch/>
        </p:blipFill>
        <p:spPr>
          <a:xfrm>
            <a:off x="3009960" y="5857920"/>
            <a:ext cx="936720" cy="179280"/>
          </a:xfrm>
          <a:prstGeom prst="rect">
            <a:avLst/>
          </a:prstGeom>
          <a:ln w="0">
            <a:noFill/>
          </a:ln>
        </p:spPr>
      </p:pic>
      <p:pic>
        <p:nvPicPr>
          <p:cNvPr id="51" name="Picture 189" descr="H:\Paper BA\Harald 110906\scans 202\110909Maus202_2siCasp8_GAPDH_1886.jpg"/>
          <p:cNvPicPr/>
          <p:nvPr/>
        </p:nvPicPr>
        <p:blipFill>
          <a:blip r:embed="rId11"/>
          <a:srcRect l="5311" t="20308" r="26661" b="31761"/>
          <a:stretch/>
        </p:blipFill>
        <p:spPr>
          <a:xfrm>
            <a:off x="971640" y="5848200"/>
            <a:ext cx="936360" cy="179640"/>
          </a:xfrm>
          <a:prstGeom prst="rect">
            <a:avLst/>
          </a:prstGeom>
          <a:ln w="0">
            <a:noFill/>
          </a:ln>
        </p:spPr>
      </p:pic>
      <p:pic>
        <p:nvPicPr>
          <p:cNvPr id="52" name="Picture 190" descr="H:\Paper BA\Harald 110906\scans 202\110909Maus202_2siCasp8_Casp8_1889.jpg"/>
          <p:cNvPicPr/>
          <p:nvPr/>
        </p:nvPicPr>
        <p:blipFill>
          <a:blip r:embed="rId12"/>
          <a:srcRect l="7587" t="9578" r="33067" b="33865"/>
          <a:stretch/>
        </p:blipFill>
        <p:spPr>
          <a:xfrm>
            <a:off x="971640" y="5619600"/>
            <a:ext cx="936360" cy="179640"/>
          </a:xfrm>
          <a:prstGeom prst="rect">
            <a:avLst/>
          </a:prstGeom>
          <a:ln w="0">
            <a:noFill/>
          </a:ln>
        </p:spPr>
      </p:pic>
      <p:pic>
        <p:nvPicPr>
          <p:cNvPr id="53" name="Picture 188" descr=""/>
          <p:cNvPicPr/>
          <p:nvPr/>
        </p:nvPicPr>
        <p:blipFill>
          <a:blip r:embed="rId13"/>
          <a:stretch/>
        </p:blipFill>
        <p:spPr>
          <a:xfrm>
            <a:off x="5191200" y="5853240"/>
            <a:ext cx="936720" cy="179280"/>
          </a:xfrm>
          <a:prstGeom prst="rect">
            <a:avLst/>
          </a:prstGeom>
          <a:ln w="0">
            <a:noFill/>
          </a:ln>
        </p:spPr>
      </p:pic>
      <p:pic>
        <p:nvPicPr>
          <p:cNvPr id="54" name="Picture 186" descr="H:\Paper BA\Harald 110906\scans 202\110909Maus202siNFkBp65_NFkBp65_1891.jpg"/>
          <p:cNvPicPr/>
          <p:nvPr/>
        </p:nvPicPr>
        <p:blipFill>
          <a:blip r:embed="rId14"/>
          <a:srcRect l="7458" t="4993" r="5953" b="22320"/>
          <a:stretch/>
        </p:blipFill>
        <p:spPr>
          <a:xfrm>
            <a:off x="5181480" y="5619600"/>
            <a:ext cx="936720" cy="179640"/>
          </a:xfrm>
          <a:prstGeom prst="rect">
            <a:avLst/>
          </a:prstGeom>
          <a:ln w="0">
            <a:noFill/>
          </a:ln>
        </p:spPr>
      </p:pic>
      <p:pic>
        <p:nvPicPr>
          <p:cNvPr id="55" name="Picture 2" descr=""/>
          <p:cNvPicPr/>
          <p:nvPr/>
        </p:nvPicPr>
        <p:blipFill>
          <a:blip r:embed="rId15"/>
          <a:stretch/>
        </p:blipFill>
        <p:spPr>
          <a:xfrm>
            <a:off x="3005280" y="5037120"/>
            <a:ext cx="934920" cy="179280"/>
          </a:xfrm>
          <a:prstGeom prst="rect">
            <a:avLst/>
          </a:prstGeom>
          <a:ln w="0">
            <a:noFill/>
          </a:ln>
        </p:spPr>
      </p:pic>
      <p:pic>
        <p:nvPicPr>
          <p:cNvPr id="56" name="Picture 85" descr=""/>
          <p:cNvPicPr/>
          <p:nvPr/>
        </p:nvPicPr>
        <p:blipFill>
          <a:blip r:embed="rId16"/>
          <a:stretch/>
        </p:blipFill>
        <p:spPr>
          <a:xfrm>
            <a:off x="3009960" y="4807080"/>
            <a:ext cx="936720" cy="179280"/>
          </a:xfrm>
          <a:prstGeom prst="rect">
            <a:avLst/>
          </a:prstGeom>
          <a:ln w="0">
            <a:noFill/>
          </a:ln>
        </p:spPr>
      </p:pic>
      <p:pic>
        <p:nvPicPr>
          <p:cNvPr id="57" name="Grafik 213" descr="Bild1.jpg"/>
          <p:cNvPicPr/>
          <p:nvPr/>
        </p:nvPicPr>
        <p:blipFill>
          <a:blip r:embed="rId17"/>
          <a:srcRect l="0" t="0" r="25237" b="-1524"/>
          <a:stretch/>
        </p:blipFill>
        <p:spPr>
          <a:xfrm>
            <a:off x="971640" y="903240"/>
            <a:ext cx="936360" cy="179280"/>
          </a:xfrm>
          <a:prstGeom prst="rect">
            <a:avLst/>
          </a:prstGeom>
          <a:ln w="0">
            <a:noFill/>
          </a:ln>
        </p:spPr>
      </p:pic>
      <p:pic>
        <p:nvPicPr>
          <p:cNvPr id="58" name="Grafik 212" descr="Bild2.jpg"/>
          <p:cNvPicPr/>
          <p:nvPr/>
        </p:nvPicPr>
        <p:blipFill>
          <a:blip r:embed="rId18"/>
          <a:srcRect l="0" t="0" r="25302" b="3150"/>
          <a:stretch/>
        </p:blipFill>
        <p:spPr>
          <a:xfrm>
            <a:off x="977760" y="1127160"/>
            <a:ext cx="936720" cy="181080"/>
          </a:xfrm>
          <a:prstGeom prst="rect">
            <a:avLst/>
          </a:prstGeom>
          <a:ln w="0">
            <a:noFill/>
          </a:ln>
        </p:spPr>
      </p:pic>
      <p:pic>
        <p:nvPicPr>
          <p:cNvPr id="59" name="Picture 94" descr=""/>
          <p:cNvPicPr/>
          <p:nvPr/>
        </p:nvPicPr>
        <p:blipFill>
          <a:blip r:embed="rId19"/>
          <a:stretch/>
        </p:blipFill>
        <p:spPr>
          <a:xfrm>
            <a:off x="3011400" y="900000"/>
            <a:ext cx="936720" cy="179640"/>
          </a:xfrm>
          <a:prstGeom prst="rect">
            <a:avLst/>
          </a:prstGeom>
          <a:ln w="0">
            <a:noFill/>
          </a:ln>
        </p:spPr>
      </p:pic>
      <p:pic>
        <p:nvPicPr>
          <p:cNvPr id="60" name="Picture 95" descr=""/>
          <p:cNvPicPr/>
          <p:nvPr/>
        </p:nvPicPr>
        <p:blipFill>
          <a:blip r:embed="rId20"/>
          <a:stretch/>
        </p:blipFill>
        <p:spPr>
          <a:xfrm>
            <a:off x="3019320" y="1133640"/>
            <a:ext cx="936720" cy="179280"/>
          </a:xfrm>
          <a:prstGeom prst="rect">
            <a:avLst/>
          </a:prstGeom>
          <a:ln w="0">
            <a:noFill/>
          </a:ln>
        </p:spPr>
      </p:pic>
      <p:pic>
        <p:nvPicPr>
          <p:cNvPr id="61" name="Picture 99" descr=""/>
          <p:cNvPicPr/>
          <p:nvPr/>
        </p:nvPicPr>
        <p:blipFill>
          <a:blip r:embed="rId21"/>
          <a:stretch/>
        </p:blipFill>
        <p:spPr>
          <a:xfrm>
            <a:off x="5191200" y="2421000"/>
            <a:ext cx="936720" cy="179280"/>
          </a:xfrm>
          <a:prstGeom prst="rect">
            <a:avLst/>
          </a:prstGeom>
          <a:ln w="0">
            <a:noFill/>
          </a:ln>
        </p:spPr>
      </p:pic>
      <p:pic>
        <p:nvPicPr>
          <p:cNvPr id="62" name="Picture 98" descr=""/>
          <p:cNvPicPr/>
          <p:nvPr/>
        </p:nvPicPr>
        <p:blipFill>
          <a:blip r:embed="rId22"/>
          <a:stretch/>
        </p:blipFill>
        <p:spPr>
          <a:xfrm>
            <a:off x="5191200" y="2657520"/>
            <a:ext cx="936720" cy="179280"/>
          </a:xfrm>
          <a:prstGeom prst="rect">
            <a:avLst/>
          </a:prstGeom>
          <a:ln w="0">
            <a:noFill/>
          </a:ln>
        </p:spPr>
      </p:pic>
      <p:pic>
        <p:nvPicPr>
          <p:cNvPr id="63" name="Picture 98" descr=""/>
          <p:cNvPicPr/>
          <p:nvPr/>
        </p:nvPicPr>
        <p:blipFill>
          <a:blip r:embed="rId23"/>
          <a:stretch/>
        </p:blipFill>
        <p:spPr>
          <a:xfrm>
            <a:off x="3016080" y="2657520"/>
            <a:ext cx="936720" cy="179280"/>
          </a:xfrm>
          <a:prstGeom prst="rect">
            <a:avLst/>
          </a:prstGeom>
          <a:ln w="0">
            <a:noFill/>
          </a:ln>
        </p:spPr>
      </p:pic>
      <p:pic>
        <p:nvPicPr>
          <p:cNvPr id="64" name="Picture 97" descr=""/>
          <p:cNvPicPr/>
          <p:nvPr/>
        </p:nvPicPr>
        <p:blipFill>
          <a:blip r:embed="rId24"/>
          <a:stretch/>
        </p:blipFill>
        <p:spPr>
          <a:xfrm>
            <a:off x="3011400" y="2419200"/>
            <a:ext cx="936720" cy="179640"/>
          </a:xfrm>
          <a:prstGeom prst="rect">
            <a:avLst/>
          </a:prstGeom>
          <a:ln w="0">
            <a:noFill/>
          </a:ln>
        </p:spPr>
      </p:pic>
      <p:pic>
        <p:nvPicPr>
          <p:cNvPr id="65" name="Picture 100" descr=""/>
          <p:cNvPicPr/>
          <p:nvPr/>
        </p:nvPicPr>
        <p:blipFill>
          <a:blip r:embed="rId25"/>
          <a:srcRect l="0" t="0" r="27228" b="5366"/>
          <a:stretch/>
        </p:blipFill>
        <p:spPr>
          <a:xfrm>
            <a:off x="982800" y="2671920"/>
            <a:ext cx="936360" cy="179280"/>
          </a:xfrm>
          <a:prstGeom prst="rect">
            <a:avLst/>
          </a:prstGeom>
          <a:ln w="0">
            <a:noFill/>
          </a:ln>
        </p:spPr>
      </p:pic>
      <p:pic>
        <p:nvPicPr>
          <p:cNvPr id="66" name="Picture 101" descr=""/>
          <p:cNvPicPr/>
          <p:nvPr/>
        </p:nvPicPr>
        <p:blipFill>
          <a:blip r:embed="rId26"/>
          <a:srcRect l="0" t="0" r="26165" b="7749"/>
          <a:stretch/>
        </p:blipFill>
        <p:spPr>
          <a:xfrm>
            <a:off x="973080" y="2428920"/>
            <a:ext cx="936720" cy="179280"/>
          </a:xfrm>
          <a:prstGeom prst="rect">
            <a:avLst/>
          </a:prstGeom>
          <a:ln w="0">
            <a:noFill/>
          </a:ln>
        </p:spPr>
      </p:pic>
      <p:graphicFrame>
        <p:nvGraphicFramePr>
          <p:cNvPr id="67" name="Object 72"/>
          <p:cNvGraphicFramePr/>
          <p:nvPr/>
        </p:nvGraphicFramePr>
        <p:xfrm>
          <a:off x="3000240" y="1884240"/>
          <a:ext cx="936720" cy="179640"/>
        </p:xfrm>
        <a:graphic>
          <a:graphicData uri="http://schemas.openxmlformats.org/presentationml/2006/ole">
            <p:oleObj r:id="rId27" spid="">
              <p:embed/>
              <p:pic>
                <p:nvPicPr>
                  <p:cNvPr id="68" name="Object 72" descr=""/>
                  <p:cNvPicPr/>
                  <p:nvPr/>
                </p:nvPicPr>
                <p:blipFill>
                  <a:blip r:embed="rId28"/>
                  <a:stretch/>
                </p:blipFill>
                <p:spPr>
                  <a:xfrm>
                    <a:off x="3000240" y="1884240"/>
                    <a:ext cx="936720" cy="1796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69" name="Object 71"/>
          <p:cNvGraphicFramePr/>
          <p:nvPr/>
        </p:nvGraphicFramePr>
        <p:xfrm>
          <a:off x="3009960" y="1650960"/>
          <a:ext cx="936720" cy="179280"/>
        </p:xfrm>
        <a:graphic>
          <a:graphicData uri="http://schemas.openxmlformats.org/presentationml/2006/ole">
            <p:oleObj r:id="rId29" spid="">
              <p:embed/>
              <p:pic>
                <p:nvPicPr>
                  <p:cNvPr id="70" name="Object 71" descr=""/>
                  <p:cNvPicPr/>
                  <p:nvPr/>
                </p:nvPicPr>
                <p:blipFill>
                  <a:blip r:embed="rId30"/>
                  <a:stretch/>
                </p:blipFill>
                <p:spPr>
                  <a:xfrm>
                    <a:off x="3009960" y="1650960"/>
                    <a:ext cx="936720" cy="1792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pic>
        <p:nvPicPr>
          <p:cNvPr id="71" name="Picture 11" descr=""/>
          <p:cNvPicPr/>
          <p:nvPr/>
        </p:nvPicPr>
        <p:blipFill>
          <a:blip r:embed="rId31"/>
          <a:stretch/>
        </p:blipFill>
        <p:spPr>
          <a:xfrm>
            <a:off x="5175360" y="4799160"/>
            <a:ext cx="934920" cy="179280"/>
          </a:xfrm>
          <a:prstGeom prst="rect">
            <a:avLst/>
          </a:prstGeom>
          <a:ln w="0">
            <a:noFill/>
          </a:ln>
        </p:spPr>
      </p:pic>
      <p:pic>
        <p:nvPicPr>
          <p:cNvPr id="72" name="Picture 10" descr=""/>
          <p:cNvPicPr/>
          <p:nvPr/>
        </p:nvPicPr>
        <p:blipFill>
          <a:blip r:embed="rId32"/>
          <a:stretch/>
        </p:blipFill>
        <p:spPr>
          <a:xfrm>
            <a:off x="5173560" y="5051520"/>
            <a:ext cx="935280" cy="179280"/>
          </a:xfrm>
          <a:prstGeom prst="rect">
            <a:avLst/>
          </a:prstGeom>
          <a:ln w="0">
            <a:noFill/>
          </a:ln>
        </p:spPr>
      </p:pic>
      <p:pic>
        <p:nvPicPr>
          <p:cNvPr id="73" name="Picture 98" descr=""/>
          <p:cNvPicPr/>
          <p:nvPr/>
        </p:nvPicPr>
        <p:blipFill>
          <a:blip r:embed="rId33"/>
          <a:stretch/>
        </p:blipFill>
        <p:spPr>
          <a:xfrm>
            <a:off x="5186520" y="4251240"/>
            <a:ext cx="934920" cy="179640"/>
          </a:xfrm>
          <a:prstGeom prst="rect">
            <a:avLst/>
          </a:prstGeom>
          <a:ln w="0">
            <a:noFill/>
          </a:ln>
        </p:spPr>
      </p:pic>
      <p:pic>
        <p:nvPicPr>
          <p:cNvPr id="74" name="Picture 97" descr=""/>
          <p:cNvPicPr/>
          <p:nvPr/>
        </p:nvPicPr>
        <p:blipFill>
          <a:blip r:embed="rId34"/>
          <a:stretch/>
        </p:blipFill>
        <p:spPr>
          <a:xfrm>
            <a:off x="5173560" y="4006800"/>
            <a:ext cx="935280" cy="179280"/>
          </a:xfrm>
          <a:prstGeom prst="rect">
            <a:avLst/>
          </a:prstGeom>
          <a:ln w="0">
            <a:noFill/>
          </a:ln>
        </p:spPr>
      </p:pic>
      <p:pic>
        <p:nvPicPr>
          <p:cNvPr id="75" name="Picture 95" descr=""/>
          <p:cNvPicPr/>
          <p:nvPr/>
        </p:nvPicPr>
        <p:blipFill>
          <a:blip r:embed="rId35"/>
          <a:stretch/>
        </p:blipFill>
        <p:spPr>
          <a:xfrm>
            <a:off x="3019320" y="4255920"/>
            <a:ext cx="935280" cy="179640"/>
          </a:xfrm>
          <a:prstGeom prst="rect">
            <a:avLst/>
          </a:prstGeom>
          <a:ln w="0">
            <a:noFill/>
          </a:ln>
        </p:spPr>
      </p:pic>
      <p:pic>
        <p:nvPicPr>
          <p:cNvPr id="76" name="Picture 94" descr=""/>
          <p:cNvPicPr/>
          <p:nvPr/>
        </p:nvPicPr>
        <p:blipFill>
          <a:blip r:embed="rId36"/>
          <a:stretch/>
        </p:blipFill>
        <p:spPr>
          <a:xfrm>
            <a:off x="3002040" y="4010040"/>
            <a:ext cx="934920" cy="179280"/>
          </a:xfrm>
          <a:prstGeom prst="rect">
            <a:avLst/>
          </a:prstGeom>
          <a:ln w="0">
            <a:noFill/>
          </a:ln>
        </p:spPr>
      </p:pic>
      <p:pic>
        <p:nvPicPr>
          <p:cNvPr id="77" name="Grafik 404" descr="Bild9.jpg"/>
          <p:cNvPicPr/>
          <p:nvPr/>
        </p:nvPicPr>
        <p:blipFill>
          <a:blip r:embed="rId37"/>
          <a:srcRect l="0" t="0" r="26161" b="7011"/>
          <a:stretch/>
        </p:blipFill>
        <p:spPr>
          <a:xfrm>
            <a:off x="966960" y="4013280"/>
            <a:ext cx="934920" cy="179280"/>
          </a:xfrm>
          <a:prstGeom prst="rect">
            <a:avLst/>
          </a:prstGeom>
          <a:ln w="0">
            <a:noFill/>
          </a:ln>
        </p:spPr>
      </p:pic>
      <p:pic>
        <p:nvPicPr>
          <p:cNvPr id="78" name="Grafik 405" descr="Bild10.jpg"/>
          <p:cNvPicPr/>
          <p:nvPr/>
        </p:nvPicPr>
        <p:blipFill>
          <a:blip r:embed="rId38"/>
          <a:srcRect l="0" t="0" r="25779" b="1661"/>
          <a:stretch/>
        </p:blipFill>
        <p:spPr>
          <a:xfrm>
            <a:off x="963720" y="4249800"/>
            <a:ext cx="934920" cy="179280"/>
          </a:xfrm>
          <a:prstGeom prst="rect">
            <a:avLst/>
          </a:prstGeom>
          <a:ln w="0">
            <a:noFill/>
          </a:ln>
        </p:spPr>
      </p:pic>
      <p:pic>
        <p:nvPicPr>
          <p:cNvPr id="79" name="Picture 91" descr=""/>
          <p:cNvPicPr/>
          <p:nvPr/>
        </p:nvPicPr>
        <p:blipFill>
          <a:blip r:embed="rId39"/>
          <a:stretch/>
        </p:blipFill>
        <p:spPr>
          <a:xfrm>
            <a:off x="5181480" y="3449520"/>
            <a:ext cx="935280" cy="179640"/>
          </a:xfrm>
          <a:prstGeom prst="rect">
            <a:avLst/>
          </a:prstGeom>
          <a:ln w="0">
            <a:noFill/>
          </a:ln>
        </p:spPr>
      </p:pic>
      <p:graphicFrame>
        <p:nvGraphicFramePr>
          <p:cNvPr id="80" name="Object 63"/>
          <p:cNvGraphicFramePr/>
          <p:nvPr/>
        </p:nvGraphicFramePr>
        <p:xfrm>
          <a:off x="3005280" y="3214800"/>
          <a:ext cx="934920" cy="179280"/>
        </p:xfrm>
        <a:graphic>
          <a:graphicData uri="http://schemas.openxmlformats.org/presentationml/2006/ole">
            <p:oleObj r:id="rId40" spid="">
              <p:embed/>
              <p:pic>
                <p:nvPicPr>
                  <p:cNvPr id="81" name="Object 63" descr=""/>
                  <p:cNvPicPr/>
                  <p:nvPr/>
                </p:nvPicPr>
                <p:blipFill>
                  <a:blip r:embed="rId41"/>
                  <a:stretch/>
                </p:blipFill>
                <p:spPr>
                  <a:xfrm>
                    <a:off x="3005280" y="3214800"/>
                    <a:ext cx="934920" cy="1792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pic>
        <p:nvPicPr>
          <p:cNvPr id="82" name="Grafik 304" descr="Bild8.jpg"/>
          <p:cNvPicPr/>
          <p:nvPr/>
        </p:nvPicPr>
        <p:blipFill>
          <a:blip r:embed="rId42"/>
          <a:srcRect l="0" t="0" r="25725" b="6089"/>
          <a:stretch/>
        </p:blipFill>
        <p:spPr>
          <a:xfrm>
            <a:off x="971640" y="3451320"/>
            <a:ext cx="934920" cy="179280"/>
          </a:xfrm>
          <a:prstGeom prst="rect">
            <a:avLst/>
          </a:prstGeom>
          <a:ln w="0">
            <a:noFill/>
          </a:ln>
        </p:spPr>
      </p:pic>
      <p:pic>
        <p:nvPicPr>
          <p:cNvPr id="83" name="Grafik 305" descr="Bild7.jpg"/>
          <p:cNvPicPr/>
          <p:nvPr/>
        </p:nvPicPr>
        <p:blipFill>
          <a:blip r:embed="rId43"/>
          <a:srcRect l="0" t="0" r="23594" b="12153"/>
          <a:stretch/>
        </p:blipFill>
        <p:spPr>
          <a:xfrm>
            <a:off x="971640" y="3213000"/>
            <a:ext cx="934920" cy="179640"/>
          </a:xfrm>
          <a:prstGeom prst="rect">
            <a:avLst/>
          </a:prstGeom>
          <a:ln w="0">
            <a:noFill/>
          </a:ln>
        </p:spPr>
      </p:pic>
      <p:pic>
        <p:nvPicPr>
          <p:cNvPr id="84" name="Picture 94" descr=""/>
          <p:cNvPicPr/>
          <p:nvPr/>
        </p:nvPicPr>
        <p:blipFill>
          <a:blip r:embed="rId44"/>
          <a:stretch/>
        </p:blipFill>
        <p:spPr>
          <a:xfrm>
            <a:off x="5178600" y="1660680"/>
            <a:ext cx="934920" cy="179280"/>
          </a:xfrm>
          <a:prstGeom prst="rect">
            <a:avLst/>
          </a:prstGeom>
          <a:ln w="0">
            <a:noFill/>
          </a:ln>
        </p:spPr>
      </p:pic>
      <p:pic>
        <p:nvPicPr>
          <p:cNvPr id="85" name="Picture 94" descr=""/>
          <p:cNvPicPr/>
          <p:nvPr/>
        </p:nvPicPr>
        <p:blipFill>
          <a:blip r:embed="rId45"/>
          <a:stretch/>
        </p:blipFill>
        <p:spPr>
          <a:xfrm>
            <a:off x="5172120" y="1897200"/>
            <a:ext cx="934920" cy="179280"/>
          </a:xfrm>
          <a:prstGeom prst="rect">
            <a:avLst/>
          </a:prstGeom>
          <a:ln w="0">
            <a:noFill/>
          </a:ln>
        </p:spPr>
      </p:pic>
      <p:graphicFrame>
        <p:nvGraphicFramePr>
          <p:cNvPr id="86" name="Object 108"/>
          <p:cNvGraphicFramePr/>
          <p:nvPr/>
        </p:nvGraphicFramePr>
        <p:xfrm>
          <a:off x="971640" y="1881360"/>
          <a:ext cx="934920" cy="179280"/>
        </p:xfrm>
        <a:graphic>
          <a:graphicData uri="http://schemas.openxmlformats.org/presentationml/2006/ole">
            <p:oleObj r:id="rId46" spid="">
              <p:embed/>
              <p:pic>
                <p:nvPicPr>
                  <p:cNvPr id="87" name="Object 108" descr=""/>
                  <p:cNvPicPr/>
                  <p:nvPr/>
                </p:nvPicPr>
                <p:blipFill>
                  <a:blip r:embed="rId47"/>
                  <a:stretch/>
                </p:blipFill>
                <p:spPr>
                  <a:xfrm>
                    <a:off x="971640" y="1881360"/>
                    <a:ext cx="934920" cy="1792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88" name="Object 69"/>
          <p:cNvGraphicFramePr/>
          <p:nvPr/>
        </p:nvGraphicFramePr>
        <p:xfrm>
          <a:off x="5175360" y="1133640"/>
          <a:ext cx="934920" cy="179280"/>
        </p:xfrm>
        <a:graphic>
          <a:graphicData uri="http://schemas.openxmlformats.org/presentationml/2006/ole">
            <p:oleObj r:id="rId48" spid="">
              <p:embed/>
              <p:pic>
                <p:nvPicPr>
                  <p:cNvPr id="89" name="Object 69" descr=""/>
                  <p:cNvPicPr/>
                  <p:nvPr/>
                </p:nvPicPr>
                <p:blipFill>
                  <a:blip r:embed="rId49"/>
                  <a:stretch/>
                </p:blipFill>
                <p:spPr>
                  <a:xfrm>
                    <a:off x="5175360" y="1133640"/>
                    <a:ext cx="934920" cy="1792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90" name="Object 66"/>
          <p:cNvGraphicFramePr/>
          <p:nvPr/>
        </p:nvGraphicFramePr>
        <p:xfrm>
          <a:off x="5178600" y="896760"/>
          <a:ext cx="934920" cy="179640"/>
        </p:xfrm>
        <a:graphic>
          <a:graphicData uri="http://schemas.openxmlformats.org/presentationml/2006/ole">
            <p:oleObj r:id="rId50" spid="">
              <p:embed/>
              <p:pic>
                <p:nvPicPr>
                  <p:cNvPr id="91" name="Object 66" descr=""/>
                  <p:cNvPicPr/>
                  <p:nvPr/>
                </p:nvPicPr>
                <p:blipFill>
                  <a:blip r:embed="rId51"/>
                  <a:stretch/>
                </p:blipFill>
                <p:spPr>
                  <a:xfrm>
                    <a:off x="5178600" y="896760"/>
                    <a:ext cx="934920" cy="1796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92" name="Text Box 25"/>
          <p:cNvSpPr/>
          <p:nvPr/>
        </p:nvSpPr>
        <p:spPr>
          <a:xfrm>
            <a:off x="5218560" y="9477360"/>
            <a:ext cx="16437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600" spc="-1" strike="noStrike">
                <a:solidFill>
                  <a:srgbClr val="000000"/>
                </a:solidFill>
                <a:latin typeface="Arial"/>
              </a:rPr>
              <a:t>Suppl. Figure 1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Text Box 26"/>
          <p:cNvSpPr/>
          <p:nvPr/>
        </p:nvSpPr>
        <p:spPr>
          <a:xfrm>
            <a:off x="71280" y="47520"/>
            <a:ext cx="509760" cy="9237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2400" spc="-1" strike="noStrike">
                <a:solidFill>
                  <a:srgbClr val="000000"/>
                </a:solidFill>
                <a:latin typeface="Arial"/>
              </a:rPr>
              <a:t>A</a:t>
            </a:r>
            <a:endParaRPr b="1" lang="en-US" sz="2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24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2400" spc="-1" strike="noStrike">
                <a:solidFill>
                  <a:srgbClr val="000000"/>
                </a:solidFill>
                <a:latin typeface="Arial"/>
              </a:rPr>
              <a:t>	</a:t>
            </a:r>
            <a:endParaRPr b="1" lang="en-US" sz="2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2400" spc="-1" strike="noStrike">
                <a:solidFill>
                  <a:srgbClr val="000000"/>
                </a:solidFill>
                <a:latin typeface="Arial"/>
              </a:rPr>
              <a:t>              </a:t>
            </a:r>
            <a:r>
              <a:rPr b="1" lang="de-DE" sz="2400" spc="-1" strike="noStrike">
                <a:solidFill>
                  <a:srgbClr val="000000"/>
                </a:solidFill>
                <a:latin typeface="Arial"/>
              </a:rPr>
              <a:t>B</a:t>
            </a:r>
            <a:r>
              <a:rPr b="1" lang="de-DE" sz="24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24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2400" spc="-1" strike="noStrike">
                <a:solidFill>
                  <a:srgbClr val="000000"/>
                </a:solidFill>
                <a:latin typeface="Arial"/>
              </a:rPr>
              <a:t>	</a:t>
            </a:r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Text Box 7"/>
          <p:cNvSpPr/>
          <p:nvPr/>
        </p:nvSpPr>
        <p:spPr>
          <a:xfrm>
            <a:off x="295200" y="865080"/>
            <a:ext cx="646560" cy="251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8400" rIns="68400" tIns="34200" bIns="34200" anchor="t">
            <a:spAutoFit/>
          </a:bodyPr>
          <a:p>
            <a:pPr>
              <a:tabLst>
                <a:tab algn="l" pos="0"/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Casp-8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Text Box 8"/>
          <p:cNvSpPr/>
          <p:nvPr/>
        </p:nvSpPr>
        <p:spPr>
          <a:xfrm>
            <a:off x="281880" y="1111320"/>
            <a:ext cx="687600" cy="251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8400" rIns="68400" tIns="34200" bIns="34200" anchor="t">
            <a:spAutoFit/>
          </a:bodyPr>
          <a:p>
            <a:pPr>
              <a:tabLst>
                <a:tab algn="l" pos="0"/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GAPDH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Text Box 39"/>
          <p:cNvSpPr/>
          <p:nvPr/>
        </p:nvSpPr>
        <p:spPr>
          <a:xfrm rot="19348200">
            <a:off x="804240" y="613800"/>
            <a:ext cx="661680" cy="251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8400" rIns="68400" tIns="34200" bIns="34200" anchor="t">
            <a:spAutoFit/>
          </a:bodyPr>
          <a:p>
            <a:pPr>
              <a:tabLst>
                <a:tab algn="l" pos="0"/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      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co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Text Box 2"/>
          <p:cNvSpPr/>
          <p:nvPr/>
        </p:nvSpPr>
        <p:spPr>
          <a:xfrm>
            <a:off x="2594520" y="868320"/>
            <a:ext cx="401040" cy="251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8400" rIns="68400" tIns="34200" bIns="34200" anchor="t">
            <a:spAutoFit/>
          </a:bodyPr>
          <a:p>
            <a:pPr>
              <a:tabLst>
                <a:tab algn="l" pos="0"/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p53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Text Box 3"/>
          <p:cNvSpPr/>
          <p:nvPr/>
        </p:nvSpPr>
        <p:spPr>
          <a:xfrm>
            <a:off x="2329560" y="1112760"/>
            <a:ext cx="687600" cy="251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8400" rIns="68400" tIns="34200" bIns="34200" anchor="t">
            <a:spAutoFit/>
          </a:bodyPr>
          <a:p>
            <a:pPr>
              <a:tabLst>
                <a:tab algn="l" pos="0"/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GAPDH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Text Box 39"/>
          <p:cNvSpPr/>
          <p:nvPr/>
        </p:nvSpPr>
        <p:spPr>
          <a:xfrm rot="19239600">
            <a:off x="1301040" y="391680"/>
            <a:ext cx="911160" cy="251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8400" rIns="68400" tIns="34200" bIns="34200" anchor="t">
            <a:spAutoFit/>
          </a:bodyPr>
          <a:p>
            <a:pPr>
              <a:tabLst>
                <a:tab algn="l" pos="0"/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sicontrol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Text Box 39"/>
          <p:cNvSpPr/>
          <p:nvPr/>
        </p:nvSpPr>
        <p:spPr>
          <a:xfrm rot="19224600">
            <a:off x="1577520" y="385560"/>
            <a:ext cx="925560" cy="251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8400" rIns="68400" tIns="34200" bIns="34200" anchor="t">
            <a:spAutoFit/>
          </a:bodyPr>
          <a:p>
            <a:pPr>
              <a:tabLst>
                <a:tab algn="l" pos="0"/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siCasp-8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Text Box 39"/>
          <p:cNvSpPr/>
          <p:nvPr/>
        </p:nvSpPr>
        <p:spPr>
          <a:xfrm rot="19348200">
            <a:off x="2847240" y="620280"/>
            <a:ext cx="660240" cy="251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8400" rIns="68400" tIns="34200" bIns="34200" anchor="t">
            <a:spAutoFit/>
          </a:bodyPr>
          <a:p>
            <a:pPr>
              <a:tabLst>
                <a:tab algn="l" pos="0"/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      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co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Text Box 39"/>
          <p:cNvSpPr/>
          <p:nvPr/>
        </p:nvSpPr>
        <p:spPr>
          <a:xfrm rot="19239600">
            <a:off x="3310920" y="387000"/>
            <a:ext cx="911160" cy="251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8400" rIns="68400" tIns="34200" bIns="34200" anchor="t">
            <a:spAutoFit/>
          </a:bodyPr>
          <a:p>
            <a:pPr>
              <a:tabLst>
                <a:tab algn="l" pos="0"/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sicontrol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Text Box 39"/>
          <p:cNvSpPr/>
          <p:nvPr/>
        </p:nvSpPr>
        <p:spPr>
          <a:xfrm rot="19224600">
            <a:off x="3609360" y="390600"/>
            <a:ext cx="923760" cy="251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8400" rIns="68400" tIns="34200" bIns="34200" anchor="t">
            <a:spAutoFit/>
          </a:bodyPr>
          <a:p>
            <a:pPr>
              <a:tabLst>
                <a:tab algn="l" pos="0"/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sip53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Text Box 2"/>
          <p:cNvSpPr/>
          <p:nvPr/>
        </p:nvSpPr>
        <p:spPr>
          <a:xfrm>
            <a:off x="4394880" y="871560"/>
            <a:ext cx="797400" cy="251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8400" rIns="68400" tIns="34200" bIns="34200" anchor="t">
            <a:spAutoFit/>
          </a:bodyPr>
          <a:p>
            <a:pPr>
              <a:tabLst>
                <a:tab algn="l" pos="0"/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NF</a:t>
            </a:r>
            <a:r>
              <a:rPr b="1" lang="de-DE" sz="1200" spc="-1" strike="noStrike">
                <a:solidFill>
                  <a:srgbClr val="000000"/>
                </a:solidFill>
                <a:latin typeface="Symbol"/>
                <a:ea typeface="Symbol"/>
              </a:rPr>
              <a:t>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Bp65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Text Box 3"/>
          <p:cNvSpPr/>
          <p:nvPr/>
        </p:nvSpPr>
        <p:spPr>
          <a:xfrm>
            <a:off x="4502880" y="1109520"/>
            <a:ext cx="687600" cy="251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8400" rIns="68400" tIns="34200" bIns="34200" anchor="t">
            <a:spAutoFit/>
          </a:bodyPr>
          <a:p>
            <a:pPr>
              <a:tabLst>
                <a:tab algn="l" pos="0"/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GAPDH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Text Box 39"/>
          <p:cNvSpPr/>
          <p:nvPr/>
        </p:nvSpPr>
        <p:spPr>
          <a:xfrm rot="19348200">
            <a:off x="5042880" y="618480"/>
            <a:ext cx="661680" cy="251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8400" rIns="68400" tIns="34200" bIns="34200" anchor="t">
            <a:spAutoFit/>
          </a:bodyPr>
          <a:p>
            <a:pPr>
              <a:tabLst>
                <a:tab algn="l" pos="0"/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      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co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Text Box 39"/>
          <p:cNvSpPr/>
          <p:nvPr/>
        </p:nvSpPr>
        <p:spPr>
          <a:xfrm rot="19239600">
            <a:off x="5517000" y="396360"/>
            <a:ext cx="909720" cy="251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8400" rIns="68400" tIns="34200" bIns="34200" anchor="t">
            <a:spAutoFit/>
          </a:bodyPr>
          <a:p>
            <a:pPr>
              <a:tabLst>
                <a:tab algn="l" pos="0"/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sicontrol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Text Box 39"/>
          <p:cNvSpPr/>
          <p:nvPr/>
        </p:nvSpPr>
        <p:spPr>
          <a:xfrm rot="19224600">
            <a:off x="5862600" y="369360"/>
            <a:ext cx="924120" cy="43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8400" rIns="68400" tIns="34200" bIns="34200" anchor="t">
            <a:spAutoFit/>
          </a:bodyPr>
          <a:p>
            <a:pPr>
              <a:tabLst>
                <a:tab algn="l" pos="0"/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siNF</a:t>
            </a:r>
            <a:r>
              <a:rPr b="1" lang="de-DE" sz="1200" spc="-1" strike="noStrike">
                <a:solidFill>
                  <a:srgbClr val="000000"/>
                </a:solidFill>
                <a:latin typeface="Symbol"/>
                <a:ea typeface="Symbol"/>
              </a:rPr>
              <a:t>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Bp65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Rechteck 117"/>
          <p:cNvSpPr/>
          <p:nvPr/>
        </p:nvSpPr>
        <p:spPr>
          <a:xfrm>
            <a:off x="968400" y="898560"/>
            <a:ext cx="934920" cy="179280"/>
          </a:xfrm>
          <a:prstGeom prst="rect">
            <a:avLst/>
          </a:pr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Rechteck 118"/>
          <p:cNvSpPr/>
          <p:nvPr/>
        </p:nvSpPr>
        <p:spPr>
          <a:xfrm>
            <a:off x="968400" y="1133640"/>
            <a:ext cx="934920" cy="179280"/>
          </a:xfrm>
          <a:prstGeom prst="rect">
            <a:avLst/>
          </a:pr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Rechteck 119"/>
          <p:cNvSpPr/>
          <p:nvPr/>
        </p:nvSpPr>
        <p:spPr>
          <a:xfrm>
            <a:off x="3009960" y="896760"/>
            <a:ext cx="934920" cy="179640"/>
          </a:xfrm>
          <a:prstGeom prst="rect">
            <a:avLst/>
          </a:pr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Rechteck 120"/>
          <p:cNvSpPr/>
          <p:nvPr/>
        </p:nvSpPr>
        <p:spPr>
          <a:xfrm>
            <a:off x="3009960" y="1131840"/>
            <a:ext cx="934920" cy="179280"/>
          </a:xfrm>
          <a:prstGeom prst="rect">
            <a:avLst/>
          </a:pr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Rechteck 121"/>
          <p:cNvSpPr/>
          <p:nvPr/>
        </p:nvSpPr>
        <p:spPr>
          <a:xfrm>
            <a:off x="5178600" y="893880"/>
            <a:ext cx="934920" cy="179280"/>
          </a:xfrm>
          <a:prstGeom prst="rect">
            <a:avLst/>
          </a:pr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Rechteck 122"/>
          <p:cNvSpPr/>
          <p:nvPr/>
        </p:nvSpPr>
        <p:spPr>
          <a:xfrm>
            <a:off x="5178600" y="1139760"/>
            <a:ext cx="934920" cy="179280"/>
          </a:xfrm>
          <a:prstGeom prst="rect">
            <a:avLst/>
          </a:pr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Text Box 7"/>
          <p:cNvSpPr/>
          <p:nvPr/>
        </p:nvSpPr>
        <p:spPr>
          <a:xfrm>
            <a:off x="430920" y="627120"/>
            <a:ext cx="654120" cy="251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8400" rIns="68400" tIns="34200" bIns="34200" anchor="t">
            <a:spAutoFit/>
          </a:bodyPr>
          <a:p>
            <a:pPr>
              <a:tabLst>
                <a:tab algn="l" pos="0"/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ALL-54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Text Box 7"/>
          <p:cNvSpPr/>
          <p:nvPr/>
        </p:nvSpPr>
        <p:spPr>
          <a:xfrm>
            <a:off x="295200" y="1623960"/>
            <a:ext cx="646560" cy="251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8400" rIns="68400" tIns="34200" bIns="34200" anchor="t">
            <a:spAutoFit/>
          </a:bodyPr>
          <a:p>
            <a:pPr>
              <a:tabLst>
                <a:tab algn="l" pos="0"/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Casp-8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Text Box 8"/>
          <p:cNvSpPr/>
          <p:nvPr/>
        </p:nvSpPr>
        <p:spPr>
          <a:xfrm>
            <a:off x="281880" y="1870200"/>
            <a:ext cx="687600" cy="251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8400" rIns="68400" tIns="34200" bIns="34200" anchor="t">
            <a:spAutoFit/>
          </a:bodyPr>
          <a:p>
            <a:pPr>
              <a:tabLst>
                <a:tab algn="l" pos="0"/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GAPDH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Text Box 2"/>
          <p:cNvSpPr/>
          <p:nvPr/>
        </p:nvSpPr>
        <p:spPr>
          <a:xfrm>
            <a:off x="2594520" y="1627200"/>
            <a:ext cx="401040" cy="251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8400" rIns="68400" tIns="34200" bIns="34200" anchor="t">
            <a:spAutoFit/>
          </a:bodyPr>
          <a:p>
            <a:pPr>
              <a:tabLst>
                <a:tab algn="l" pos="0"/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p53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Text Box 3"/>
          <p:cNvSpPr/>
          <p:nvPr/>
        </p:nvSpPr>
        <p:spPr>
          <a:xfrm>
            <a:off x="2329560" y="1871640"/>
            <a:ext cx="687600" cy="251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8400" rIns="68400" tIns="34200" bIns="34200" anchor="t">
            <a:spAutoFit/>
          </a:bodyPr>
          <a:p>
            <a:pPr>
              <a:tabLst>
                <a:tab algn="l" pos="0"/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GAPDH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Text Box 2"/>
          <p:cNvSpPr/>
          <p:nvPr/>
        </p:nvSpPr>
        <p:spPr>
          <a:xfrm>
            <a:off x="4394880" y="1630440"/>
            <a:ext cx="797400" cy="251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8400" rIns="68400" tIns="34200" bIns="34200" anchor="t">
            <a:spAutoFit/>
          </a:bodyPr>
          <a:p>
            <a:pPr>
              <a:tabLst>
                <a:tab algn="l" pos="0"/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NF</a:t>
            </a:r>
            <a:r>
              <a:rPr b="1" lang="de-DE" sz="1200" spc="-1" strike="noStrike">
                <a:solidFill>
                  <a:srgbClr val="000000"/>
                </a:solidFill>
                <a:latin typeface="Symbol"/>
                <a:ea typeface="Symbol"/>
              </a:rPr>
              <a:t>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Bp65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Text Box 3"/>
          <p:cNvSpPr/>
          <p:nvPr/>
        </p:nvSpPr>
        <p:spPr>
          <a:xfrm>
            <a:off x="4502880" y="1868400"/>
            <a:ext cx="687600" cy="251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8400" rIns="68400" tIns="34200" bIns="34200" anchor="t">
            <a:spAutoFit/>
          </a:bodyPr>
          <a:p>
            <a:pPr>
              <a:tabLst>
                <a:tab algn="l" pos="0"/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GAPDH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Rechteck 117"/>
          <p:cNvSpPr/>
          <p:nvPr/>
        </p:nvSpPr>
        <p:spPr>
          <a:xfrm>
            <a:off x="968400" y="1657440"/>
            <a:ext cx="934920" cy="179280"/>
          </a:xfrm>
          <a:prstGeom prst="rect">
            <a:avLst/>
          </a:pr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Rechteck 118"/>
          <p:cNvSpPr/>
          <p:nvPr/>
        </p:nvSpPr>
        <p:spPr>
          <a:xfrm>
            <a:off x="968400" y="1892160"/>
            <a:ext cx="934920" cy="179640"/>
          </a:xfrm>
          <a:prstGeom prst="rect">
            <a:avLst/>
          </a:pr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Rechteck 119"/>
          <p:cNvSpPr/>
          <p:nvPr/>
        </p:nvSpPr>
        <p:spPr>
          <a:xfrm>
            <a:off x="3009960" y="1655640"/>
            <a:ext cx="934920" cy="179640"/>
          </a:xfrm>
          <a:prstGeom prst="rect">
            <a:avLst/>
          </a:pr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Rechteck 120"/>
          <p:cNvSpPr/>
          <p:nvPr/>
        </p:nvSpPr>
        <p:spPr>
          <a:xfrm>
            <a:off x="3009960" y="1890720"/>
            <a:ext cx="934920" cy="179280"/>
          </a:xfrm>
          <a:prstGeom prst="rect">
            <a:avLst/>
          </a:pr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Rechteck 121"/>
          <p:cNvSpPr/>
          <p:nvPr/>
        </p:nvSpPr>
        <p:spPr>
          <a:xfrm>
            <a:off x="5178600" y="1652760"/>
            <a:ext cx="934920" cy="179280"/>
          </a:xfrm>
          <a:prstGeom prst="rect">
            <a:avLst/>
          </a:pr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Rechteck 122"/>
          <p:cNvSpPr/>
          <p:nvPr/>
        </p:nvSpPr>
        <p:spPr>
          <a:xfrm>
            <a:off x="5178600" y="1898640"/>
            <a:ext cx="934920" cy="179280"/>
          </a:xfrm>
          <a:prstGeom prst="rect">
            <a:avLst/>
          </a:pr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Text Box 7"/>
          <p:cNvSpPr/>
          <p:nvPr/>
        </p:nvSpPr>
        <p:spPr>
          <a:xfrm>
            <a:off x="421560" y="1401840"/>
            <a:ext cx="739440" cy="251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8400" rIns="68400" tIns="34200" bIns="34200" anchor="t">
            <a:spAutoFit/>
          </a:bodyPr>
          <a:p>
            <a:pPr>
              <a:tabLst>
                <a:tab algn="l" pos="0"/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ALL-177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Text Box 7"/>
          <p:cNvSpPr/>
          <p:nvPr/>
        </p:nvSpPr>
        <p:spPr>
          <a:xfrm>
            <a:off x="295200" y="2392200"/>
            <a:ext cx="646560" cy="251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8400" rIns="68400" tIns="34200" bIns="34200" anchor="t">
            <a:spAutoFit/>
          </a:bodyPr>
          <a:p>
            <a:pPr>
              <a:tabLst>
                <a:tab algn="l" pos="0"/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Casp-8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Text Box 8"/>
          <p:cNvSpPr/>
          <p:nvPr/>
        </p:nvSpPr>
        <p:spPr>
          <a:xfrm>
            <a:off x="281880" y="2638440"/>
            <a:ext cx="687600" cy="251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8400" rIns="68400" tIns="34200" bIns="34200" anchor="t">
            <a:spAutoFit/>
          </a:bodyPr>
          <a:p>
            <a:pPr>
              <a:tabLst>
                <a:tab algn="l" pos="0"/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GAPDH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Text Box 2"/>
          <p:cNvSpPr/>
          <p:nvPr/>
        </p:nvSpPr>
        <p:spPr>
          <a:xfrm>
            <a:off x="2594520" y="2395440"/>
            <a:ext cx="401040" cy="251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8400" rIns="68400" tIns="34200" bIns="34200" anchor="t">
            <a:spAutoFit/>
          </a:bodyPr>
          <a:p>
            <a:pPr>
              <a:tabLst>
                <a:tab algn="l" pos="0"/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p53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Text Box 3"/>
          <p:cNvSpPr/>
          <p:nvPr/>
        </p:nvSpPr>
        <p:spPr>
          <a:xfrm>
            <a:off x="2329560" y="2660760"/>
            <a:ext cx="687600" cy="251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8400" rIns="68400" tIns="34200" bIns="34200" anchor="t">
            <a:spAutoFit/>
          </a:bodyPr>
          <a:p>
            <a:pPr>
              <a:tabLst>
                <a:tab algn="l" pos="0"/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GAPDH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Text Box 2"/>
          <p:cNvSpPr/>
          <p:nvPr/>
        </p:nvSpPr>
        <p:spPr>
          <a:xfrm>
            <a:off x="4394880" y="2398680"/>
            <a:ext cx="797400" cy="251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8400" rIns="68400" tIns="34200" bIns="34200" anchor="t">
            <a:spAutoFit/>
          </a:bodyPr>
          <a:p>
            <a:pPr>
              <a:tabLst>
                <a:tab algn="l" pos="0"/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NF</a:t>
            </a:r>
            <a:r>
              <a:rPr b="1" lang="de-DE" sz="1200" spc="-1" strike="noStrike">
                <a:solidFill>
                  <a:srgbClr val="000000"/>
                </a:solidFill>
                <a:latin typeface="Symbol"/>
                <a:ea typeface="Symbol"/>
              </a:rPr>
              <a:t>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Bp65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Text Box 3"/>
          <p:cNvSpPr/>
          <p:nvPr/>
        </p:nvSpPr>
        <p:spPr>
          <a:xfrm>
            <a:off x="4502880" y="2657520"/>
            <a:ext cx="687600" cy="251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8400" rIns="68400" tIns="34200" bIns="34200" anchor="t">
            <a:spAutoFit/>
          </a:bodyPr>
          <a:p>
            <a:pPr>
              <a:tabLst>
                <a:tab algn="l" pos="0"/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GAPDH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Rechteck 117"/>
          <p:cNvSpPr/>
          <p:nvPr/>
        </p:nvSpPr>
        <p:spPr>
          <a:xfrm>
            <a:off x="968400" y="2425680"/>
            <a:ext cx="934920" cy="179280"/>
          </a:xfrm>
          <a:prstGeom prst="rect">
            <a:avLst/>
          </a:pr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Rechteck 118"/>
          <p:cNvSpPr/>
          <p:nvPr/>
        </p:nvSpPr>
        <p:spPr>
          <a:xfrm>
            <a:off x="968400" y="2660760"/>
            <a:ext cx="934920" cy="179280"/>
          </a:xfrm>
          <a:prstGeom prst="rect">
            <a:avLst/>
          </a:pr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Rechteck 119"/>
          <p:cNvSpPr/>
          <p:nvPr/>
        </p:nvSpPr>
        <p:spPr>
          <a:xfrm>
            <a:off x="3009960" y="2424240"/>
            <a:ext cx="934920" cy="179280"/>
          </a:xfrm>
          <a:prstGeom prst="rect">
            <a:avLst/>
          </a:pr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Rechteck 120"/>
          <p:cNvSpPr/>
          <p:nvPr/>
        </p:nvSpPr>
        <p:spPr>
          <a:xfrm>
            <a:off x="3009960" y="2658960"/>
            <a:ext cx="934920" cy="179640"/>
          </a:xfrm>
          <a:prstGeom prst="rect">
            <a:avLst/>
          </a:pr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Rechteck 121"/>
          <p:cNvSpPr/>
          <p:nvPr/>
        </p:nvSpPr>
        <p:spPr>
          <a:xfrm>
            <a:off x="5178600" y="2421000"/>
            <a:ext cx="934920" cy="179280"/>
          </a:xfrm>
          <a:prstGeom prst="rect">
            <a:avLst/>
          </a:pr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Rechteck 122"/>
          <p:cNvSpPr/>
          <p:nvPr/>
        </p:nvSpPr>
        <p:spPr>
          <a:xfrm>
            <a:off x="5178600" y="2666880"/>
            <a:ext cx="934920" cy="179640"/>
          </a:xfrm>
          <a:prstGeom prst="rect">
            <a:avLst/>
          </a:pr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Text Box 7"/>
          <p:cNvSpPr/>
          <p:nvPr/>
        </p:nvSpPr>
        <p:spPr>
          <a:xfrm>
            <a:off x="411840" y="2158920"/>
            <a:ext cx="739440" cy="251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8400" rIns="68400" tIns="34200" bIns="34200" anchor="t">
            <a:spAutoFit/>
          </a:bodyPr>
          <a:p>
            <a:pPr>
              <a:tabLst>
                <a:tab algn="l" pos="0"/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ALL-199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Text Box 7"/>
          <p:cNvSpPr/>
          <p:nvPr/>
        </p:nvSpPr>
        <p:spPr>
          <a:xfrm>
            <a:off x="295200" y="3181320"/>
            <a:ext cx="646560" cy="251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8400" rIns="68400" tIns="34200" bIns="34200" anchor="t">
            <a:spAutoFit/>
          </a:bodyPr>
          <a:p>
            <a:pPr>
              <a:tabLst>
                <a:tab algn="l" pos="0"/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Casp-8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Text Box 8"/>
          <p:cNvSpPr/>
          <p:nvPr/>
        </p:nvSpPr>
        <p:spPr>
          <a:xfrm>
            <a:off x="281880" y="3427560"/>
            <a:ext cx="687600" cy="251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8400" rIns="68400" tIns="34200" bIns="34200" anchor="t">
            <a:spAutoFit/>
          </a:bodyPr>
          <a:p>
            <a:pPr>
              <a:tabLst>
                <a:tab algn="l" pos="0"/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GAPDH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Text Box 2"/>
          <p:cNvSpPr/>
          <p:nvPr/>
        </p:nvSpPr>
        <p:spPr>
          <a:xfrm>
            <a:off x="2594520" y="3184560"/>
            <a:ext cx="401040" cy="251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8400" rIns="68400" tIns="34200" bIns="34200" anchor="t">
            <a:spAutoFit/>
          </a:bodyPr>
          <a:p>
            <a:pPr>
              <a:tabLst>
                <a:tab algn="l" pos="0"/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p53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Text Box 3"/>
          <p:cNvSpPr/>
          <p:nvPr/>
        </p:nvSpPr>
        <p:spPr>
          <a:xfrm>
            <a:off x="2329560" y="3429000"/>
            <a:ext cx="687600" cy="251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8400" rIns="68400" tIns="34200" bIns="34200" anchor="t">
            <a:spAutoFit/>
          </a:bodyPr>
          <a:p>
            <a:pPr>
              <a:tabLst>
                <a:tab algn="l" pos="0"/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GAPDH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Text Box 2"/>
          <p:cNvSpPr/>
          <p:nvPr/>
        </p:nvSpPr>
        <p:spPr>
          <a:xfrm>
            <a:off x="4394880" y="3187800"/>
            <a:ext cx="797400" cy="251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8400" rIns="68400" tIns="34200" bIns="34200" anchor="t">
            <a:spAutoFit/>
          </a:bodyPr>
          <a:p>
            <a:pPr>
              <a:tabLst>
                <a:tab algn="l" pos="0"/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NF</a:t>
            </a:r>
            <a:r>
              <a:rPr b="1" lang="de-DE" sz="1200" spc="-1" strike="noStrike">
                <a:solidFill>
                  <a:srgbClr val="000000"/>
                </a:solidFill>
                <a:latin typeface="Symbol"/>
                <a:ea typeface="Symbol"/>
              </a:rPr>
              <a:t>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Bp65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Text Box 3"/>
          <p:cNvSpPr/>
          <p:nvPr/>
        </p:nvSpPr>
        <p:spPr>
          <a:xfrm>
            <a:off x="4502880" y="3425760"/>
            <a:ext cx="687600" cy="251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8400" rIns="68400" tIns="34200" bIns="34200" anchor="t">
            <a:spAutoFit/>
          </a:bodyPr>
          <a:p>
            <a:pPr>
              <a:tabLst>
                <a:tab algn="l" pos="0"/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GAPDH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Rechteck 117"/>
          <p:cNvSpPr/>
          <p:nvPr/>
        </p:nvSpPr>
        <p:spPr>
          <a:xfrm>
            <a:off x="968400" y="3214800"/>
            <a:ext cx="934920" cy="179280"/>
          </a:xfrm>
          <a:prstGeom prst="rect">
            <a:avLst/>
          </a:pr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Rechteck 118"/>
          <p:cNvSpPr/>
          <p:nvPr/>
        </p:nvSpPr>
        <p:spPr>
          <a:xfrm>
            <a:off x="968400" y="3449520"/>
            <a:ext cx="934920" cy="179640"/>
          </a:xfrm>
          <a:prstGeom prst="rect">
            <a:avLst/>
          </a:pr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Rechteck 119"/>
          <p:cNvSpPr/>
          <p:nvPr/>
        </p:nvSpPr>
        <p:spPr>
          <a:xfrm>
            <a:off x="3009960" y="3213000"/>
            <a:ext cx="934920" cy="179640"/>
          </a:xfrm>
          <a:prstGeom prst="rect">
            <a:avLst/>
          </a:pr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Rechteck 120"/>
          <p:cNvSpPr/>
          <p:nvPr/>
        </p:nvSpPr>
        <p:spPr>
          <a:xfrm>
            <a:off x="3009960" y="3448080"/>
            <a:ext cx="934920" cy="179280"/>
          </a:xfrm>
          <a:prstGeom prst="rect">
            <a:avLst/>
          </a:pr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Rechteck 121"/>
          <p:cNvSpPr/>
          <p:nvPr/>
        </p:nvSpPr>
        <p:spPr>
          <a:xfrm>
            <a:off x="5178600" y="3209760"/>
            <a:ext cx="934920" cy="179640"/>
          </a:xfrm>
          <a:prstGeom prst="rect">
            <a:avLst/>
          </a:pr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Rechteck 122"/>
          <p:cNvSpPr/>
          <p:nvPr/>
        </p:nvSpPr>
        <p:spPr>
          <a:xfrm>
            <a:off x="5178600" y="3456000"/>
            <a:ext cx="934920" cy="179280"/>
          </a:xfrm>
          <a:prstGeom prst="rect">
            <a:avLst/>
          </a:pr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Text Box 7"/>
          <p:cNvSpPr/>
          <p:nvPr/>
        </p:nvSpPr>
        <p:spPr>
          <a:xfrm>
            <a:off x="412200" y="2946240"/>
            <a:ext cx="756360" cy="251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8400" rIns="68400" tIns="34200" bIns="34200" anchor="t">
            <a:spAutoFit/>
          </a:bodyPr>
          <a:p>
            <a:pPr>
              <a:tabLst>
                <a:tab algn="l" pos="0"/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ALL-10S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Text Box 7"/>
          <p:cNvSpPr/>
          <p:nvPr/>
        </p:nvSpPr>
        <p:spPr>
          <a:xfrm>
            <a:off x="295200" y="3979800"/>
            <a:ext cx="646560" cy="251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8400" rIns="68400" tIns="34200" bIns="34200" anchor="t">
            <a:spAutoFit/>
          </a:bodyPr>
          <a:p>
            <a:pPr>
              <a:tabLst>
                <a:tab algn="l" pos="0"/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Casp-8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Text Box 8"/>
          <p:cNvSpPr/>
          <p:nvPr/>
        </p:nvSpPr>
        <p:spPr>
          <a:xfrm>
            <a:off x="281880" y="4226040"/>
            <a:ext cx="687600" cy="251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8400" rIns="68400" tIns="34200" bIns="34200" anchor="t">
            <a:spAutoFit/>
          </a:bodyPr>
          <a:p>
            <a:pPr>
              <a:tabLst>
                <a:tab algn="l" pos="0"/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GAPDH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Text Box 2"/>
          <p:cNvSpPr/>
          <p:nvPr/>
        </p:nvSpPr>
        <p:spPr>
          <a:xfrm>
            <a:off x="2594520" y="3983040"/>
            <a:ext cx="401040" cy="251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8400" rIns="68400" tIns="34200" bIns="34200" anchor="t">
            <a:spAutoFit/>
          </a:bodyPr>
          <a:p>
            <a:pPr>
              <a:tabLst>
                <a:tab algn="l" pos="0"/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p53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Text Box 3"/>
          <p:cNvSpPr/>
          <p:nvPr/>
        </p:nvSpPr>
        <p:spPr>
          <a:xfrm>
            <a:off x="2329560" y="4227480"/>
            <a:ext cx="687600" cy="251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8400" rIns="68400" tIns="34200" bIns="34200" anchor="t">
            <a:spAutoFit/>
          </a:bodyPr>
          <a:p>
            <a:pPr>
              <a:tabLst>
                <a:tab algn="l" pos="0"/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GAPDH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Text Box 2"/>
          <p:cNvSpPr/>
          <p:nvPr/>
        </p:nvSpPr>
        <p:spPr>
          <a:xfrm>
            <a:off x="4394880" y="3986280"/>
            <a:ext cx="797400" cy="251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8400" rIns="68400" tIns="34200" bIns="34200" anchor="t">
            <a:spAutoFit/>
          </a:bodyPr>
          <a:p>
            <a:pPr>
              <a:tabLst>
                <a:tab algn="l" pos="0"/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NF</a:t>
            </a:r>
            <a:r>
              <a:rPr b="1" lang="de-DE" sz="1200" spc="-1" strike="noStrike">
                <a:solidFill>
                  <a:srgbClr val="000000"/>
                </a:solidFill>
                <a:latin typeface="Symbol"/>
                <a:ea typeface="Symbol"/>
              </a:rPr>
              <a:t>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Bp65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Text Box 3"/>
          <p:cNvSpPr/>
          <p:nvPr/>
        </p:nvSpPr>
        <p:spPr>
          <a:xfrm>
            <a:off x="4502880" y="4224240"/>
            <a:ext cx="687600" cy="251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8400" rIns="68400" tIns="34200" bIns="34200" anchor="t">
            <a:spAutoFit/>
          </a:bodyPr>
          <a:p>
            <a:pPr>
              <a:tabLst>
                <a:tab algn="l" pos="0"/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GAPDH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Rechteck 117"/>
          <p:cNvSpPr/>
          <p:nvPr/>
        </p:nvSpPr>
        <p:spPr>
          <a:xfrm>
            <a:off x="968400" y="4013280"/>
            <a:ext cx="934920" cy="179280"/>
          </a:xfrm>
          <a:prstGeom prst="rect">
            <a:avLst/>
          </a:pr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Rechteck 118"/>
          <p:cNvSpPr/>
          <p:nvPr/>
        </p:nvSpPr>
        <p:spPr>
          <a:xfrm>
            <a:off x="968400" y="4248000"/>
            <a:ext cx="934920" cy="179640"/>
          </a:xfrm>
          <a:prstGeom prst="rect">
            <a:avLst/>
          </a:pr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Rechteck 119"/>
          <p:cNvSpPr/>
          <p:nvPr/>
        </p:nvSpPr>
        <p:spPr>
          <a:xfrm>
            <a:off x="3009960" y="4011480"/>
            <a:ext cx="934920" cy="179640"/>
          </a:xfrm>
          <a:prstGeom prst="rect">
            <a:avLst/>
          </a:pr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Rechteck 120"/>
          <p:cNvSpPr/>
          <p:nvPr/>
        </p:nvSpPr>
        <p:spPr>
          <a:xfrm>
            <a:off x="3009960" y="4246560"/>
            <a:ext cx="934920" cy="179280"/>
          </a:xfrm>
          <a:prstGeom prst="rect">
            <a:avLst/>
          </a:pr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Rechteck 121"/>
          <p:cNvSpPr/>
          <p:nvPr/>
        </p:nvSpPr>
        <p:spPr>
          <a:xfrm>
            <a:off x="5178600" y="4008600"/>
            <a:ext cx="934920" cy="179280"/>
          </a:xfrm>
          <a:prstGeom prst="rect">
            <a:avLst/>
          </a:pr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Rechteck 122"/>
          <p:cNvSpPr/>
          <p:nvPr/>
        </p:nvSpPr>
        <p:spPr>
          <a:xfrm>
            <a:off x="5178600" y="4254480"/>
            <a:ext cx="934920" cy="179280"/>
          </a:xfrm>
          <a:prstGeom prst="rect">
            <a:avLst/>
          </a:pr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Text Box 7"/>
          <p:cNvSpPr/>
          <p:nvPr/>
        </p:nvSpPr>
        <p:spPr>
          <a:xfrm>
            <a:off x="402480" y="3768840"/>
            <a:ext cx="739440" cy="251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8400" rIns="68400" tIns="34200" bIns="34200" anchor="t">
            <a:spAutoFit/>
          </a:bodyPr>
          <a:p>
            <a:pPr>
              <a:tabLst>
                <a:tab algn="l" pos="0"/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ALL-188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Text Box 7"/>
          <p:cNvSpPr/>
          <p:nvPr/>
        </p:nvSpPr>
        <p:spPr>
          <a:xfrm>
            <a:off x="295200" y="4773600"/>
            <a:ext cx="646560" cy="251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8400" rIns="68400" tIns="34200" bIns="34200" anchor="t">
            <a:spAutoFit/>
          </a:bodyPr>
          <a:p>
            <a:pPr>
              <a:tabLst>
                <a:tab algn="l" pos="0"/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Casp-8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Text Box 8"/>
          <p:cNvSpPr/>
          <p:nvPr/>
        </p:nvSpPr>
        <p:spPr>
          <a:xfrm>
            <a:off x="281880" y="5019840"/>
            <a:ext cx="687600" cy="251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8400" rIns="68400" tIns="34200" bIns="34200" anchor="t">
            <a:spAutoFit/>
          </a:bodyPr>
          <a:p>
            <a:pPr>
              <a:tabLst>
                <a:tab algn="l" pos="0"/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GAPDH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Text Box 2"/>
          <p:cNvSpPr/>
          <p:nvPr/>
        </p:nvSpPr>
        <p:spPr>
          <a:xfrm>
            <a:off x="2594520" y="4776840"/>
            <a:ext cx="401040" cy="251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8400" rIns="68400" tIns="34200" bIns="34200" anchor="t">
            <a:spAutoFit/>
          </a:bodyPr>
          <a:p>
            <a:pPr>
              <a:tabLst>
                <a:tab algn="l" pos="0"/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p53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Text Box 3"/>
          <p:cNvSpPr/>
          <p:nvPr/>
        </p:nvSpPr>
        <p:spPr>
          <a:xfrm>
            <a:off x="2329560" y="5000760"/>
            <a:ext cx="687600" cy="251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8400" rIns="68400" tIns="34200" bIns="34200" anchor="t">
            <a:spAutoFit/>
          </a:bodyPr>
          <a:p>
            <a:pPr>
              <a:tabLst>
                <a:tab algn="l" pos="0"/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GAPDH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Text Box 2"/>
          <p:cNvSpPr/>
          <p:nvPr/>
        </p:nvSpPr>
        <p:spPr>
          <a:xfrm>
            <a:off x="4394880" y="4780080"/>
            <a:ext cx="797400" cy="251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8400" rIns="68400" tIns="34200" bIns="34200" anchor="t">
            <a:spAutoFit/>
          </a:bodyPr>
          <a:p>
            <a:pPr>
              <a:tabLst>
                <a:tab algn="l" pos="0"/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NF</a:t>
            </a:r>
            <a:r>
              <a:rPr b="1" lang="de-DE" sz="1200" spc="-1" strike="noStrike">
                <a:solidFill>
                  <a:srgbClr val="000000"/>
                </a:solidFill>
                <a:latin typeface="Symbol"/>
                <a:ea typeface="Symbol"/>
              </a:rPr>
              <a:t>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Bp65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Text Box 3"/>
          <p:cNvSpPr/>
          <p:nvPr/>
        </p:nvSpPr>
        <p:spPr>
          <a:xfrm>
            <a:off x="4502880" y="5018040"/>
            <a:ext cx="687600" cy="251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8400" rIns="68400" tIns="34200" bIns="34200" anchor="t">
            <a:spAutoFit/>
          </a:bodyPr>
          <a:p>
            <a:pPr>
              <a:tabLst>
                <a:tab algn="l" pos="0"/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GAPDH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Rechteck 117"/>
          <p:cNvSpPr/>
          <p:nvPr/>
        </p:nvSpPr>
        <p:spPr>
          <a:xfrm>
            <a:off x="968400" y="4807080"/>
            <a:ext cx="934920" cy="179280"/>
          </a:xfrm>
          <a:prstGeom prst="rect">
            <a:avLst/>
          </a:pr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Rechteck 118"/>
          <p:cNvSpPr/>
          <p:nvPr/>
        </p:nvSpPr>
        <p:spPr>
          <a:xfrm>
            <a:off x="968400" y="5041800"/>
            <a:ext cx="934920" cy="179640"/>
          </a:xfrm>
          <a:prstGeom prst="rect">
            <a:avLst/>
          </a:pr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Rechteck 119"/>
          <p:cNvSpPr/>
          <p:nvPr/>
        </p:nvSpPr>
        <p:spPr>
          <a:xfrm>
            <a:off x="3009960" y="4805280"/>
            <a:ext cx="934920" cy="179640"/>
          </a:xfrm>
          <a:prstGeom prst="rect">
            <a:avLst/>
          </a:pr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Rechteck 120"/>
          <p:cNvSpPr/>
          <p:nvPr/>
        </p:nvSpPr>
        <p:spPr>
          <a:xfrm>
            <a:off x="3009960" y="5040360"/>
            <a:ext cx="934920" cy="179280"/>
          </a:xfrm>
          <a:prstGeom prst="rect">
            <a:avLst/>
          </a:pr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Rechteck 121"/>
          <p:cNvSpPr/>
          <p:nvPr/>
        </p:nvSpPr>
        <p:spPr>
          <a:xfrm>
            <a:off x="5178600" y="4802040"/>
            <a:ext cx="934920" cy="179640"/>
          </a:xfrm>
          <a:prstGeom prst="rect">
            <a:avLst/>
          </a:pr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Rechteck 122"/>
          <p:cNvSpPr/>
          <p:nvPr/>
        </p:nvSpPr>
        <p:spPr>
          <a:xfrm>
            <a:off x="5178600" y="5048280"/>
            <a:ext cx="934920" cy="179280"/>
          </a:xfrm>
          <a:prstGeom prst="rect">
            <a:avLst/>
          </a:pr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Text Box 7"/>
          <p:cNvSpPr/>
          <p:nvPr/>
        </p:nvSpPr>
        <p:spPr>
          <a:xfrm>
            <a:off x="431280" y="4540320"/>
            <a:ext cx="671040" cy="251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8400" rIns="68400" tIns="34200" bIns="34200" anchor="t">
            <a:spAutoFit/>
          </a:bodyPr>
          <a:p>
            <a:pPr>
              <a:tabLst>
                <a:tab algn="l" pos="0"/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ALL-4S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Text Box 7"/>
          <p:cNvSpPr/>
          <p:nvPr/>
        </p:nvSpPr>
        <p:spPr>
          <a:xfrm>
            <a:off x="298080" y="5584680"/>
            <a:ext cx="646560" cy="251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8400" rIns="68400" tIns="34200" bIns="34200" anchor="t">
            <a:spAutoFit/>
          </a:bodyPr>
          <a:p>
            <a:pPr>
              <a:tabLst>
                <a:tab algn="l" pos="0"/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Casp-8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Text Box 8"/>
          <p:cNvSpPr/>
          <p:nvPr/>
        </p:nvSpPr>
        <p:spPr>
          <a:xfrm>
            <a:off x="285120" y="5830920"/>
            <a:ext cx="687600" cy="251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8400" rIns="68400" tIns="34200" bIns="34200" anchor="t">
            <a:spAutoFit/>
          </a:bodyPr>
          <a:p>
            <a:pPr>
              <a:tabLst>
                <a:tab algn="l" pos="0"/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GAPDH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Text Box 2"/>
          <p:cNvSpPr/>
          <p:nvPr/>
        </p:nvSpPr>
        <p:spPr>
          <a:xfrm>
            <a:off x="2597760" y="5587920"/>
            <a:ext cx="401040" cy="251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8400" rIns="68400" tIns="34200" bIns="34200" anchor="t">
            <a:spAutoFit/>
          </a:bodyPr>
          <a:p>
            <a:pPr>
              <a:tabLst>
                <a:tab algn="l" pos="0"/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p53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Text Box 3"/>
          <p:cNvSpPr/>
          <p:nvPr/>
        </p:nvSpPr>
        <p:spPr>
          <a:xfrm>
            <a:off x="2332800" y="5832360"/>
            <a:ext cx="687600" cy="251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8400" rIns="68400" tIns="34200" bIns="34200" anchor="t">
            <a:spAutoFit/>
          </a:bodyPr>
          <a:p>
            <a:pPr>
              <a:tabLst>
                <a:tab algn="l" pos="0"/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GAPDH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Text Box 2"/>
          <p:cNvSpPr/>
          <p:nvPr/>
        </p:nvSpPr>
        <p:spPr>
          <a:xfrm>
            <a:off x="4398120" y="5591160"/>
            <a:ext cx="797400" cy="251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8400" rIns="68400" tIns="34200" bIns="34200" anchor="t">
            <a:spAutoFit/>
          </a:bodyPr>
          <a:p>
            <a:pPr>
              <a:tabLst>
                <a:tab algn="l" pos="0"/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NF</a:t>
            </a:r>
            <a:r>
              <a:rPr b="1" lang="de-DE" sz="1200" spc="-1" strike="noStrike">
                <a:solidFill>
                  <a:srgbClr val="000000"/>
                </a:solidFill>
                <a:latin typeface="Symbol"/>
                <a:ea typeface="Symbol"/>
              </a:rPr>
              <a:t>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Bp65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Text Box 3"/>
          <p:cNvSpPr/>
          <p:nvPr/>
        </p:nvSpPr>
        <p:spPr>
          <a:xfrm>
            <a:off x="4506120" y="5829480"/>
            <a:ext cx="687600" cy="251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8400" rIns="68400" tIns="34200" bIns="34200" anchor="t">
            <a:spAutoFit/>
          </a:bodyPr>
          <a:p>
            <a:pPr>
              <a:tabLst>
                <a:tab algn="l" pos="0"/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GAPDH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Rechteck 117"/>
          <p:cNvSpPr/>
          <p:nvPr/>
        </p:nvSpPr>
        <p:spPr>
          <a:xfrm>
            <a:off x="971640" y="5618160"/>
            <a:ext cx="934920" cy="179280"/>
          </a:xfrm>
          <a:prstGeom prst="rect">
            <a:avLst/>
          </a:pr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Rechteck 118"/>
          <p:cNvSpPr/>
          <p:nvPr/>
        </p:nvSpPr>
        <p:spPr>
          <a:xfrm>
            <a:off x="971640" y="5853240"/>
            <a:ext cx="934920" cy="179280"/>
          </a:xfrm>
          <a:prstGeom prst="rect">
            <a:avLst/>
          </a:pr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Rechteck 119"/>
          <p:cNvSpPr/>
          <p:nvPr/>
        </p:nvSpPr>
        <p:spPr>
          <a:xfrm>
            <a:off x="3013200" y="5616720"/>
            <a:ext cx="934920" cy="179280"/>
          </a:xfrm>
          <a:prstGeom prst="rect">
            <a:avLst/>
          </a:pr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Rechteck 120"/>
          <p:cNvSpPr/>
          <p:nvPr/>
        </p:nvSpPr>
        <p:spPr>
          <a:xfrm>
            <a:off x="3013200" y="5851440"/>
            <a:ext cx="934920" cy="179640"/>
          </a:xfrm>
          <a:prstGeom prst="rect">
            <a:avLst/>
          </a:pr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Rechteck 121"/>
          <p:cNvSpPr/>
          <p:nvPr/>
        </p:nvSpPr>
        <p:spPr>
          <a:xfrm>
            <a:off x="5181480" y="5613480"/>
            <a:ext cx="935280" cy="179280"/>
          </a:xfrm>
          <a:prstGeom prst="rect">
            <a:avLst/>
          </a:pr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Rechteck 122"/>
          <p:cNvSpPr/>
          <p:nvPr/>
        </p:nvSpPr>
        <p:spPr>
          <a:xfrm>
            <a:off x="5181480" y="5859360"/>
            <a:ext cx="935280" cy="179640"/>
          </a:xfrm>
          <a:prstGeom prst="rect">
            <a:avLst/>
          </a:pr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Text Box 7"/>
          <p:cNvSpPr/>
          <p:nvPr/>
        </p:nvSpPr>
        <p:spPr>
          <a:xfrm>
            <a:off x="424800" y="5362560"/>
            <a:ext cx="739440" cy="251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8400" rIns="68400" tIns="34200" bIns="34200" anchor="t">
            <a:spAutoFit/>
          </a:bodyPr>
          <a:p>
            <a:pPr>
              <a:tabLst>
                <a:tab algn="l" pos="0"/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ALL-202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94" name="Gruppieren 196"/>
          <p:cNvGrpSpPr/>
          <p:nvPr/>
        </p:nvGrpSpPr>
        <p:grpSpPr>
          <a:xfrm>
            <a:off x="583200" y="6552000"/>
            <a:ext cx="2941920" cy="1816200"/>
            <a:chOff x="583200" y="6552000"/>
            <a:chExt cx="2941920" cy="1816200"/>
          </a:xfrm>
        </p:grpSpPr>
        <p:grpSp>
          <p:nvGrpSpPr>
            <p:cNvPr id="195" name="Gruppieren 47"/>
            <p:cNvGrpSpPr/>
            <p:nvPr/>
          </p:nvGrpSpPr>
          <p:grpSpPr>
            <a:xfrm>
              <a:off x="1338120" y="7570800"/>
              <a:ext cx="1246320" cy="187200"/>
              <a:chOff x="1338120" y="7570800"/>
              <a:chExt cx="1246320" cy="187200"/>
            </a:xfrm>
          </p:grpSpPr>
          <p:pic>
            <p:nvPicPr>
              <p:cNvPr id="196" name="Grafik 38" descr="Bild2.jpg"/>
              <p:cNvPicPr/>
              <p:nvPr/>
            </p:nvPicPr>
            <p:blipFill>
              <a:blip r:embed="rId52"/>
              <a:srcRect l="49938" t="0" r="0" b="0"/>
              <a:stretch/>
            </p:blipFill>
            <p:spPr>
              <a:xfrm>
                <a:off x="1639440" y="7570800"/>
                <a:ext cx="945000" cy="1872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97" name="Grafik 46" descr="Bild2.jpg"/>
              <p:cNvPicPr/>
              <p:nvPr/>
            </p:nvPicPr>
            <p:blipFill>
              <a:blip r:embed="rId53"/>
              <a:srcRect l="17345" t="0" r="66711" b="0"/>
              <a:stretch/>
            </p:blipFill>
            <p:spPr>
              <a:xfrm>
                <a:off x="1338120" y="7570800"/>
                <a:ext cx="300960" cy="187200"/>
              </a:xfrm>
              <a:prstGeom prst="rect">
                <a:avLst/>
              </a:prstGeom>
              <a:ln w="0">
                <a:noFill/>
              </a:ln>
            </p:spPr>
          </p:pic>
        </p:grpSp>
        <p:grpSp>
          <p:nvGrpSpPr>
            <p:cNvPr id="198" name="Gruppieren 49"/>
            <p:cNvGrpSpPr/>
            <p:nvPr/>
          </p:nvGrpSpPr>
          <p:grpSpPr>
            <a:xfrm>
              <a:off x="1330200" y="7858080"/>
              <a:ext cx="1246320" cy="180720"/>
              <a:chOff x="1330200" y="7858080"/>
              <a:chExt cx="1246320" cy="180720"/>
            </a:xfrm>
          </p:grpSpPr>
          <p:pic>
            <p:nvPicPr>
              <p:cNvPr id="199" name="Picture 109" descr="090729_6er_P169_Puma032"/>
              <p:cNvPicPr/>
              <p:nvPr/>
            </p:nvPicPr>
            <p:blipFill>
              <a:blip r:embed="rId54">
                <a:lum contrast="-30000"/>
              </a:blip>
              <a:srcRect l="49983" t="0" r="0" b="0"/>
              <a:stretch/>
            </p:blipFill>
            <p:spPr>
              <a:xfrm>
                <a:off x="1612440" y="7858080"/>
                <a:ext cx="964080" cy="1807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200" name="Picture 109" descr="090729_6er_P169_Puma032"/>
              <p:cNvPicPr/>
              <p:nvPr/>
            </p:nvPicPr>
            <p:blipFill>
              <a:blip r:embed="rId55">
                <a:lum contrast="-30000"/>
              </a:blip>
              <a:srcRect l="20248" t="0" r="64861" b="0"/>
              <a:stretch/>
            </p:blipFill>
            <p:spPr>
              <a:xfrm>
                <a:off x="1330200" y="7858080"/>
                <a:ext cx="282240" cy="180720"/>
              </a:xfrm>
              <a:prstGeom prst="rect">
                <a:avLst/>
              </a:prstGeom>
              <a:ln w="0">
                <a:noFill/>
              </a:ln>
            </p:spPr>
          </p:pic>
        </p:grpSp>
        <p:grpSp>
          <p:nvGrpSpPr>
            <p:cNvPr id="201" name="Gruppieren 51"/>
            <p:cNvGrpSpPr/>
            <p:nvPr/>
          </p:nvGrpSpPr>
          <p:grpSpPr>
            <a:xfrm>
              <a:off x="1341360" y="8147160"/>
              <a:ext cx="1242360" cy="179280"/>
              <a:chOff x="1341360" y="8147160"/>
              <a:chExt cx="1242360" cy="179280"/>
            </a:xfrm>
          </p:grpSpPr>
          <p:pic>
            <p:nvPicPr>
              <p:cNvPr id="202" name="Grafik 39" descr="Bild3.jpg"/>
              <p:cNvPicPr/>
              <p:nvPr/>
            </p:nvPicPr>
            <p:blipFill>
              <a:blip r:embed="rId56"/>
              <a:srcRect l="50595" t="0" r="0" b="0"/>
              <a:stretch/>
            </p:blipFill>
            <p:spPr>
              <a:xfrm>
                <a:off x="1657080" y="8148240"/>
                <a:ext cx="926640" cy="1782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203" name="Grafik 50" descr="Bild3.jpg"/>
              <p:cNvPicPr/>
              <p:nvPr/>
            </p:nvPicPr>
            <p:blipFill>
              <a:blip r:embed="rId57"/>
              <a:srcRect l="16182" t="0" r="66873" b="0"/>
              <a:stretch/>
            </p:blipFill>
            <p:spPr>
              <a:xfrm>
                <a:off x="1341360" y="8147160"/>
                <a:ext cx="318600" cy="178560"/>
              </a:xfrm>
              <a:prstGeom prst="rect">
                <a:avLst/>
              </a:prstGeom>
              <a:ln w="0">
                <a:noFill/>
              </a:ln>
            </p:spPr>
          </p:pic>
        </p:grpSp>
        <p:sp>
          <p:nvSpPr>
            <p:cNvPr id="204" name="Text Box 5"/>
            <p:cNvSpPr/>
            <p:nvPr/>
          </p:nvSpPr>
          <p:spPr>
            <a:xfrm>
              <a:off x="736560" y="7802640"/>
              <a:ext cx="628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PUMA</a:t>
              </a: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5" name="Text Box 7"/>
            <p:cNvSpPr/>
            <p:nvPr/>
          </p:nvSpPr>
          <p:spPr>
            <a:xfrm>
              <a:off x="761400" y="7539120"/>
              <a:ext cx="577800" cy="251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68400" rIns="68400" tIns="34200" bIns="34200" anchor="t">
              <a:spAutoFit/>
            </a:bodyPr>
            <a:p>
              <a:pPr>
                <a:tabLst>
                  <a:tab algn="l" pos="0"/>
                  <a:tab algn="l" pos="684360"/>
                  <a:tab algn="l" pos="1368360"/>
                  <a:tab algn="l" pos="2052720"/>
                  <a:tab algn="l" pos="2736720"/>
                  <a:tab algn="l" pos="3421080"/>
                  <a:tab algn="l" pos="4105440"/>
                  <a:tab algn="l" pos="4789440"/>
                  <a:tab algn="l" pos="5473800"/>
                  <a:tab algn="l" pos="6157800"/>
                  <a:tab algn="l" pos="6842160"/>
                  <a:tab algn="l" pos="7526160"/>
                  <a:tab algn="l" pos="8210520"/>
                  <a:tab algn="l" pos="8894880"/>
                  <a:tab algn="l" pos="9578880"/>
                  <a:tab algn="l" pos="10263240"/>
                  <a:tab algn="l" pos="1094724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NOXA</a:t>
              </a: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6" name="Text Box 8"/>
            <p:cNvSpPr/>
            <p:nvPr/>
          </p:nvSpPr>
          <p:spPr>
            <a:xfrm>
              <a:off x="666360" y="8116920"/>
              <a:ext cx="687600" cy="251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68400" rIns="68400" tIns="34200" bIns="34200" anchor="t">
              <a:spAutoFit/>
            </a:bodyPr>
            <a:p>
              <a:pPr>
                <a:tabLst>
                  <a:tab algn="l" pos="0"/>
                  <a:tab algn="l" pos="684360"/>
                  <a:tab algn="l" pos="1368360"/>
                  <a:tab algn="l" pos="2052720"/>
                  <a:tab algn="l" pos="2736720"/>
                  <a:tab algn="l" pos="3421080"/>
                  <a:tab algn="l" pos="4105440"/>
                  <a:tab algn="l" pos="4789440"/>
                  <a:tab algn="l" pos="5473800"/>
                  <a:tab algn="l" pos="6157800"/>
                  <a:tab algn="l" pos="6842160"/>
                  <a:tab algn="l" pos="7526160"/>
                  <a:tab algn="l" pos="8210520"/>
                  <a:tab algn="l" pos="8894880"/>
                  <a:tab algn="l" pos="9578880"/>
                  <a:tab algn="l" pos="10263240"/>
                  <a:tab algn="l" pos="1094724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GAPDH</a:t>
              </a: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7" name="Text Box 39"/>
            <p:cNvSpPr/>
            <p:nvPr/>
          </p:nvSpPr>
          <p:spPr>
            <a:xfrm rot="19239600">
              <a:off x="1288080" y="7085880"/>
              <a:ext cx="911160" cy="251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8400" rIns="68400" tIns="34200" bIns="34200" anchor="t">
              <a:spAutoFit/>
            </a:bodyPr>
            <a:p>
              <a:pPr>
                <a:tabLst>
                  <a:tab algn="l" pos="0"/>
                  <a:tab algn="l" pos="684360"/>
                  <a:tab algn="l" pos="1368360"/>
                  <a:tab algn="l" pos="2052720"/>
                  <a:tab algn="l" pos="2736720"/>
                  <a:tab algn="l" pos="3421080"/>
                  <a:tab algn="l" pos="4105440"/>
                  <a:tab algn="l" pos="4789440"/>
                  <a:tab algn="l" pos="5473800"/>
                  <a:tab algn="l" pos="6157800"/>
                  <a:tab algn="l" pos="6842160"/>
                  <a:tab algn="l" pos="7526160"/>
                  <a:tab algn="l" pos="8210520"/>
                  <a:tab algn="l" pos="8894880"/>
                  <a:tab algn="l" pos="9578880"/>
                  <a:tab algn="l" pos="10263240"/>
                  <a:tab algn="l" pos="1094724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sicontrol</a:t>
              </a: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8" name="Text Box 39"/>
            <p:cNvSpPr/>
            <p:nvPr/>
          </p:nvSpPr>
          <p:spPr>
            <a:xfrm rot="19224600">
              <a:off x="1532520" y="6960600"/>
              <a:ext cx="1297080" cy="251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8400" rIns="68400" tIns="34200" bIns="34200" anchor="t">
              <a:spAutoFit/>
            </a:bodyPr>
            <a:p>
              <a:pPr>
                <a:tabLst>
                  <a:tab algn="l" pos="0"/>
                  <a:tab algn="l" pos="684360"/>
                  <a:tab algn="l" pos="1368360"/>
                  <a:tab algn="l" pos="2052720"/>
                  <a:tab algn="l" pos="2736720"/>
                  <a:tab algn="l" pos="3421080"/>
                  <a:tab algn="l" pos="4105440"/>
                  <a:tab algn="l" pos="4789440"/>
                  <a:tab algn="l" pos="5473800"/>
                  <a:tab algn="l" pos="6157800"/>
                  <a:tab algn="l" pos="6842160"/>
                  <a:tab algn="l" pos="7526160"/>
                  <a:tab algn="l" pos="8210520"/>
                  <a:tab algn="l" pos="8894880"/>
                  <a:tab algn="l" pos="9578880"/>
                  <a:tab algn="l" pos="10263240"/>
                  <a:tab algn="l" pos="1094724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siNOXA</a:t>
              </a: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9" name="Rechteck 117"/>
            <p:cNvSpPr/>
            <p:nvPr/>
          </p:nvSpPr>
          <p:spPr>
            <a:xfrm>
              <a:off x="1336320" y="7572240"/>
              <a:ext cx="1246320" cy="17928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2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0" name="Text Box 7"/>
            <p:cNvSpPr/>
            <p:nvPr/>
          </p:nvSpPr>
          <p:spPr>
            <a:xfrm>
              <a:off x="583200" y="7239600"/>
              <a:ext cx="739440" cy="251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68400" rIns="68400" tIns="34200" bIns="34200" anchor="t">
              <a:spAutoFit/>
            </a:bodyPr>
            <a:p>
              <a:pPr>
                <a:tabLst>
                  <a:tab algn="l" pos="0"/>
                  <a:tab algn="l" pos="684360"/>
                  <a:tab algn="l" pos="1368360"/>
                  <a:tab algn="l" pos="2052720"/>
                  <a:tab algn="l" pos="2736720"/>
                  <a:tab algn="l" pos="3421080"/>
                  <a:tab algn="l" pos="4105440"/>
                  <a:tab algn="l" pos="4789440"/>
                  <a:tab algn="l" pos="5473800"/>
                  <a:tab algn="l" pos="6157800"/>
                  <a:tab algn="l" pos="6842160"/>
                  <a:tab algn="l" pos="7526160"/>
                  <a:tab algn="l" pos="8210520"/>
                  <a:tab algn="l" pos="8894880"/>
                  <a:tab algn="l" pos="9578880"/>
                  <a:tab algn="l" pos="10263240"/>
                  <a:tab algn="l" pos="1094724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ALL-169</a:t>
              </a: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1" name="Text Box 39"/>
            <p:cNvSpPr/>
            <p:nvPr/>
          </p:nvSpPr>
          <p:spPr>
            <a:xfrm rot="19224600">
              <a:off x="1856160" y="6954840"/>
              <a:ext cx="1295640" cy="251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8400" rIns="68400" tIns="34200" bIns="34200" anchor="t">
              <a:spAutoFit/>
            </a:bodyPr>
            <a:p>
              <a:pPr>
                <a:tabLst>
                  <a:tab algn="l" pos="0"/>
                  <a:tab algn="l" pos="684360"/>
                  <a:tab algn="l" pos="1368360"/>
                  <a:tab algn="l" pos="2052720"/>
                  <a:tab algn="l" pos="2736720"/>
                  <a:tab algn="l" pos="3421080"/>
                  <a:tab algn="l" pos="4105440"/>
                  <a:tab algn="l" pos="4789440"/>
                  <a:tab algn="l" pos="5473800"/>
                  <a:tab algn="l" pos="6157800"/>
                  <a:tab algn="l" pos="6842160"/>
                  <a:tab algn="l" pos="7526160"/>
                  <a:tab algn="l" pos="8210520"/>
                  <a:tab algn="l" pos="8894880"/>
                  <a:tab algn="l" pos="9578880"/>
                  <a:tab algn="l" pos="10263240"/>
                  <a:tab algn="l" pos="1094724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siPUMA</a:t>
              </a: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2" name="Text Box 39"/>
            <p:cNvSpPr/>
            <p:nvPr/>
          </p:nvSpPr>
          <p:spPr>
            <a:xfrm rot="19224600">
              <a:off x="2238480" y="6915240"/>
              <a:ext cx="1297080" cy="433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8400" rIns="68400" tIns="34200" bIns="34200" anchor="t">
              <a:spAutoFit/>
            </a:bodyPr>
            <a:p>
              <a:pPr>
                <a:tabLst>
                  <a:tab algn="l" pos="0"/>
                  <a:tab algn="l" pos="684360"/>
                  <a:tab algn="l" pos="1368360"/>
                  <a:tab algn="l" pos="2052720"/>
                  <a:tab algn="l" pos="2736720"/>
                  <a:tab algn="l" pos="3421080"/>
                  <a:tab algn="l" pos="4105440"/>
                  <a:tab algn="l" pos="4789440"/>
                  <a:tab algn="l" pos="5473800"/>
                  <a:tab algn="l" pos="6157800"/>
                  <a:tab algn="l" pos="6842160"/>
                  <a:tab algn="l" pos="7526160"/>
                  <a:tab algn="l" pos="8210520"/>
                  <a:tab algn="l" pos="8894880"/>
                  <a:tab algn="l" pos="9578880"/>
                  <a:tab algn="l" pos="10263240"/>
                  <a:tab algn="l" pos="1094724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siNOXA+</a:t>
              </a: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684360"/>
                  <a:tab algn="l" pos="1368360"/>
                  <a:tab algn="l" pos="2052720"/>
                  <a:tab algn="l" pos="2736720"/>
                  <a:tab algn="l" pos="3421080"/>
                  <a:tab algn="l" pos="4105440"/>
                  <a:tab algn="l" pos="4789440"/>
                  <a:tab algn="l" pos="5473800"/>
                  <a:tab algn="l" pos="6157800"/>
                  <a:tab algn="l" pos="6842160"/>
                  <a:tab algn="l" pos="7526160"/>
                  <a:tab algn="l" pos="8210520"/>
                  <a:tab algn="l" pos="8894880"/>
                  <a:tab algn="l" pos="9578880"/>
                  <a:tab algn="l" pos="10263240"/>
                  <a:tab algn="l" pos="1094724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     </a:t>
              </a: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siPUMA</a:t>
              </a: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3" name="Rechteck 117"/>
            <p:cNvSpPr/>
            <p:nvPr/>
          </p:nvSpPr>
          <p:spPr>
            <a:xfrm>
              <a:off x="1336320" y="7853400"/>
              <a:ext cx="1246320" cy="17928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2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4" name="Rechteck 117"/>
            <p:cNvSpPr/>
            <p:nvPr/>
          </p:nvSpPr>
          <p:spPr>
            <a:xfrm>
              <a:off x="1336320" y="8148600"/>
              <a:ext cx="1246320" cy="17928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2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5" name="Gerade Verbindung 211"/>
            <p:cNvSpPr/>
            <p:nvPr/>
          </p:nvSpPr>
          <p:spPr>
            <a:xfrm>
              <a:off x="1629720" y="7572240"/>
              <a:ext cx="0" cy="1850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2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6" name="Gerade Verbindung 212"/>
            <p:cNvSpPr/>
            <p:nvPr/>
          </p:nvSpPr>
          <p:spPr>
            <a:xfrm>
              <a:off x="1632600" y="7851960"/>
              <a:ext cx="0" cy="1850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2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7" name="Gerade Verbindung 213"/>
            <p:cNvSpPr/>
            <p:nvPr/>
          </p:nvSpPr>
          <p:spPr>
            <a:xfrm>
              <a:off x="1629720" y="8139960"/>
              <a:ext cx="0" cy="1850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2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8" name="Diagramm 64" descr=""/>
          <p:cNvPicPr/>
          <p:nvPr/>
        </p:nvPicPr>
        <p:blipFill>
          <a:blip r:embed="rId1"/>
          <a:stretch/>
        </p:blipFill>
        <p:spPr>
          <a:xfrm>
            <a:off x="2298600" y="2998800"/>
            <a:ext cx="1627200" cy="2689200"/>
          </a:xfrm>
          <a:prstGeom prst="rect">
            <a:avLst/>
          </a:prstGeom>
          <a:ln w="0">
            <a:noFill/>
          </a:ln>
        </p:spPr>
      </p:pic>
      <p:sp>
        <p:nvSpPr>
          <p:cNvPr id="219" name="Text Box 25"/>
          <p:cNvSpPr/>
          <p:nvPr/>
        </p:nvSpPr>
        <p:spPr>
          <a:xfrm>
            <a:off x="5219280" y="9477360"/>
            <a:ext cx="16437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600" spc="-1" strike="noStrike">
                <a:solidFill>
                  <a:srgbClr val="000000"/>
                </a:solidFill>
                <a:latin typeface="Arial"/>
              </a:rPr>
              <a:t>Suppl. Figure 2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20" name="Gruppieren 346"/>
          <p:cNvGrpSpPr/>
          <p:nvPr/>
        </p:nvGrpSpPr>
        <p:grpSpPr>
          <a:xfrm>
            <a:off x="1861920" y="5738400"/>
            <a:ext cx="2352960" cy="1546920"/>
            <a:chOff x="1861920" y="5738400"/>
            <a:chExt cx="2352960" cy="1546920"/>
          </a:xfrm>
        </p:grpSpPr>
        <p:sp>
          <p:nvSpPr>
            <p:cNvPr id="221" name="Text Box 282"/>
            <p:cNvSpPr/>
            <p:nvPr/>
          </p:nvSpPr>
          <p:spPr>
            <a:xfrm>
              <a:off x="1908360" y="6765840"/>
              <a:ext cx="6897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</a:rPr>
                <a:t>Casp-8</a:t>
              </a: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2" name="Text Box 283"/>
            <p:cNvSpPr/>
            <p:nvPr/>
          </p:nvSpPr>
          <p:spPr>
            <a:xfrm>
              <a:off x="1861920" y="7008840"/>
              <a:ext cx="7308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GAPDH</a:t>
              </a: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223" name="Group 291"/>
            <p:cNvGrpSpPr/>
            <p:nvPr/>
          </p:nvGrpSpPr>
          <p:grpSpPr>
            <a:xfrm>
              <a:off x="2574000" y="7034400"/>
              <a:ext cx="1227600" cy="198720"/>
              <a:chOff x="2574000" y="7034400"/>
              <a:chExt cx="1227600" cy="198720"/>
            </a:xfrm>
          </p:grpSpPr>
          <p:graphicFrame>
            <p:nvGraphicFramePr>
              <p:cNvPr id="224" name="Object 292"/>
              <p:cNvGraphicFramePr/>
              <p:nvPr/>
            </p:nvGraphicFramePr>
            <p:xfrm>
              <a:off x="3190680" y="7034400"/>
              <a:ext cx="610920" cy="190800"/>
            </p:xfrm>
            <a:graphic>
              <a:graphicData uri="http://schemas.openxmlformats.org/presentationml/2006/ole">
                <p:oleObj r:id="rId2" spid="">
                  <p:embed/>
                  <p:pic>
                    <p:nvPicPr>
                      <p:cNvPr id="225" name="Object 292" descr=""/>
                      <p:cNvPicPr/>
                      <p:nvPr/>
                    </p:nvPicPr>
                    <p:blipFill>
                      <a:blip r:embed="rId3"/>
                      <a:stretch/>
                    </p:blipFill>
                    <p:spPr>
                      <a:xfrm>
                        <a:off x="3190680" y="7034400"/>
                        <a:ext cx="610920" cy="19080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graphicFrame>
            <p:nvGraphicFramePr>
              <p:cNvPr id="226" name="Object 293"/>
              <p:cNvGraphicFramePr/>
              <p:nvPr/>
            </p:nvGraphicFramePr>
            <p:xfrm>
              <a:off x="2574000" y="7034400"/>
              <a:ext cx="618480" cy="198720"/>
            </p:xfrm>
            <a:graphic>
              <a:graphicData uri="http://schemas.openxmlformats.org/presentationml/2006/ole">
                <p:oleObj r:id="rId4" spid="">
                  <p:embed/>
                  <p:pic>
                    <p:nvPicPr>
                      <p:cNvPr id="227" name="Object 293" descr=""/>
                      <p:cNvPicPr/>
                      <p:nvPr/>
                    </p:nvPicPr>
                    <p:blipFill>
                      <a:blip r:embed="rId5"/>
                      <a:stretch/>
                    </p:blipFill>
                    <p:spPr>
                      <a:xfrm>
                        <a:off x="2574000" y="7034400"/>
                        <a:ext cx="618480" cy="19872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</p:grpSp>
        <p:grpSp>
          <p:nvGrpSpPr>
            <p:cNvPr id="228" name="Group 296"/>
            <p:cNvGrpSpPr/>
            <p:nvPr/>
          </p:nvGrpSpPr>
          <p:grpSpPr>
            <a:xfrm>
              <a:off x="2571120" y="6801480"/>
              <a:ext cx="1252800" cy="195480"/>
              <a:chOff x="2571120" y="6801480"/>
              <a:chExt cx="1252800" cy="195480"/>
            </a:xfrm>
          </p:grpSpPr>
          <p:graphicFrame>
            <p:nvGraphicFramePr>
              <p:cNvPr id="229" name="Object 297"/>
              <p:cNvGraphicFramePr/>
              <p:nvPr/>
            </p:nvGraphicFramePr>
            <p:xfrm>
              <a:off x="2581920" y="6806160"/>
              <a:ext cx="608040" cy="186120"/>
            </p:xfrm>
            <a:graphic>
              <a:graphicData uri="http://schemas.openxmlformats.org/presentationml/2006/ole">
                <p:oleObj r:id="rId6" spid="">
                  <p:embed/>
                  <p:pic>
                    <p:nvPicPr>
                      <p:cNvPr id="230" name="Object 297" descr=""/>
                      <p:cNvPicPr/>
                      <p:nvPr/>
                    </p:nvPicPr>
                    <p:blipFill>
                      <a:blip r:embed="rId7"/>
                      <a:stretch/>
                    </p:blipFill>
                    <p:spPr>
                      <a:xfrm>
                        <a:off x="2581920" y="6806160"/>
                        <a:ext cx="608040" cy="18612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graphicFrame>
            <p:nvGraphicFramePr>
              <p:cNvPr id="231" name="Object 298"/>
              <p:cNvGraphicFramePr/>
              <p:nvPr/>
            </p:nvGraphicFramePr>
            <p:xfrm>
              <a:off x="3193200" y="6806160"/>
              <a:ext cx="630720" cy="190800"/>
            </p:xfrm>
            <a:graphic>
              <a:graphicData uri="http://schemas.openxmlformats.org/presentationml/2006/ole">
                <p:oleObj r:id="rId8" spid="">
                  <p:embed/>
                  <p:pic>
                    <p:nvPicPr>
                      <p:cNvPr id="232" name="Object 298" descr=""/>
                      <p:cNvPicPr/>
                      <p:nvPr/>
                    </p:nvPicPr>
                    <p:blipFill>
                      <a:blip r:embed="rId9"/>
                      <a:stretch/>
                    </p:blipFill>
                    <p:spPr>
                      <a:xfrm>
                        <a:off x="3193200" y="6806160"/>
                        <a:ext cx="630720" cy="19080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sp>
            <p:nvSpPr>
              <p:cNvPr id="233" name="Rectangle 299"/>
              <p:cNvSpPr/>
              <p:nvPr/>
            </p:nvSpPr>
            <p:spPr>
              <a:xfrm>
                <a:off x="2571120" y="6801480"/>
                <a:ext cx="1238760" cy="185040"/>
              </a:xfrm>
              <a:prstGeom prst="rect">
                <a:avLst/>
              </a:prstGeom>
              <a:noFill/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1" lang="en-US" sz="2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34" name="Text Box 284"/>
            <p:cNvSpPr/>
            <p:nvPr/>
          </p:nvSpPr>
          <p:spPr>
            <a:xfrm>
              <a:off x="2063520" y="6513480"/>
              <a:ext cx="519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</a:rPr>
                <a:t>5-FU</a:t>
              </a: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5" name="Rectangle 385"/>
            <p:cNvSpPr/>
            <p:nvPr/>
          </p:nvSpPr>
          <p:spPr>
            <a:xfrm>
              <a:off x="2580480" y="6552000"/>
              <a:ext cx="1213920" cy="18360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2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6" name="Line 388"/>
            <p:cNvSpPr/>
            <p:nvPr/>
          </p:nvSpPr>
          <p:spPr>
            <a:xfrm>
              <a:off x="2885040" y="6552000"/>
              <a:ext cx="0" cy="18360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2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7" name="Line 389"/>
            <p:cNvSpPr/>
            <p:nvPr/>
          </p:nvSpPr>
          <p:spPr>
            <a:xfrm>
              <a:off x="3187440" y="6549480"/>
              <a:ext cx="0" cy="18360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2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8" name="Line 390"/>
            <p:cNvSpPr/>
            <p:nvPr/>
          </p:nvSpPr>
          <p:spPr>
            <a:xfrm>
              <a:off x="3492360" y="6556680"/>
              <a:ext cx="0" cy="18360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2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239" name="Group 395"/>
            <p:cNvGrpSpPr/>
            <p:nvPr/>
          </p:nvGrpSpPr>
          <p:grpSpPr>
            <a:xfrm>
              <a:off x="2631240" y="6481080"/>
              <a:ext cx="1122120" cy="285840"/>
              <a:chOff x="2631240" y="6481080"/>
              <a:chExt cx="1122120" cy="285840"/>
            </a:xfrm>
          </p:grpSpPr>
          <p:sp>
            <p:nvSpPr>
              <p:cNvPr id="240" name="Text Box 396"/>
              <p:cNvSpPr/>
              <p:nvPr/>
            </p:nvSpPr>
            <p:spPr>
              <a:xfrm>
                <a:off x="2631240" y="6481080"/>
                <a:ext cx="196920" cy="281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68400" rIns="68400" tIns="34200" bIns="34200" anchor="t">
                <a:spAutoFit/>
              </a:bodyPr>
              <a:p>
                <a:pPr>
                  <a:tabLst>
                    <a:tab algn="l" pos="0"/>
                    <a:tab algn="l" pos="684360"/>
                    <a:tab algn="l" pos="1368360"/>
                    <a:tab algn="l" pos="2052720"/>
                    <a:tab algn="l" pos="2736720"/>
                    <a:tab algn="l" pos="3421080"/>
                    <a:tab algn="l" pos="4105440"/>
                    <a:tab algn="l" pos="4789440"/>
                    <a:tab algn="l" pos="5473800"/>
                    <a:tab algn="l" pos="6157800"/>
                    <a:tab algn="l" pos="6842160"/>
                    <a:tab algn="l" pos="7526160"/>
                    <a:tab algn="l" pos="8210520"/>
                    <a:tab algn="l" pos="8894880"/>
                    <a:tab algn="l" pos="9578880"/>
                    <a:tab algn="l" pos="10263240"/>
                    <a:tab algn="l" pos="10947240"/>
                  </a:tabLst>
                </a:pPr>
                <a:r>
                  <a:rPr b="1" lang="de-DE" sz="14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1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1" name="Text Box 398"/>
              <p:cNvSpPr/>
              <p:nvPr/>
            </p:nvSpPr>
            <p:spPr>
              <a:xfrm>
                <a:off x="2921040" y="6515640"/>
                <a:ext cx="226080" cy="251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68400" rIns="68400" tIns="34200" bIns="34200" anchor="t">
                <a:spAutoFit/>
              </a:bodyPr>
              <a:p>
                <a:pPr>
                  <a:tabLst>
                    <a:tab algn="l" pos="0"/>
                    <a:tab algn="l" pos="684360"/>
                    <a:tab algn="l" pos="1368360"/>
                    <a:tab algn="l" pos="2052720"/>
                    <a:tab algn="l" pos="2736720"/>
                    <a:tab algn="l" pos="3421080"/>
                    <a:tab algn="l" pos="4105440"/>
                    <a:tab algn="l" pos="4789440"/>
                    <a:tab algn="l" pos="5473800"/>
                    <a:tab algn="l" pos="6157800"/>
                    <a:tab algn="l" pos="6842160"/>
                    <a:tab algn="l" pos="7526160"/>
                    <a:tab algn="l" pos="8210520"/>
                    <a:tab algn="l" pos="8894880"/>
                    <a:tab algn="l" pos="9578880"/>
                    <a:tab algn="l" pos="10263240"/>
                    <a:tab algn="l" pos="10947240"/>
                  </a:tabLst>
                </a:pPr>
                <a:r>
                  <a:rPr b="1" lang="de-DE" sz="1200" spc="-1" strike="noStrike">
                    <a:solidFill>
                      <a:srgbClr val="000000"/>
                    </a:solidFill>
                    <a:latin typeface="Arial"/>
                  </a:rPr>
                  <a:t>+</a:t>
                </a:r>
                <a:endParaRPr b="1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2" name="Text Box 400"/>
              <p:cNvSpPr/>
              <p:nvPr/>
            </p:nvSpPr>
            <p:spPr>
              <a:xfrm>
                <a:off x="3235680" y="6484320"/>
                <a:ext cx="196920" cy="281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68400" rIns="68400" tIns="34200" bIns="34200" anchor="t">
                <a:spAutoFit/>
              </a:bodyPr>
              <a:p>
                <a:pPr>
                  <a:tabLst>
                    <a:tab algn="l" pos="0"/>
                    <a:tab algn="l" pos="684360"/>
                    <a:tab algn="l" pos="1368360"/>
                    <a:tab algn="l" pos="2052720"/>
                    <a:tab algn="l" pos="2736720"/>
                    <a:tab algn="l" pos="3421080"/>
                    <a:tab algn="l" pos="4105440"/>
                    <a:tab algn="l" pos="4789440"/>
                    <a:tab algn="l" pos="5473800"/>
                    <a:tab algn="l" pos="6157800"/>
                    <a:tab algn="l" pos="6842160"/>
                    <a:tab algn="l" pos="7526160"/>
                    <a:tab algn="l" pos="8210520"/>
                    <a:tab algn="l" pos="8894880"/>
                    <a:tab algn="l" pos="9578880"/>
                    <a:tab algn="l" pos="10263240"/>
                    <a:tab algn="l" pos="10947240"/>
                  </a:tabLst>
                </a:pPr>
                <a:r>
                  <a:rPr b="1" lang="de-DE" sz="14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1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3" name="Text Box 402"/>
              <p:cNvSpPr/>
              <p:nvPr/>
            </p:nvSpPr>
            <p:spPr>
              <a:xfrm>
                <a:off x="3527280" y="6514560"/>
                <a:ext cx="226080" cy="251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68400" rIns="68400" tIns="34200" bIns="34200" anchor="t">
                <a:spAutoFit/>
              </a:bodyPr>
              <a:p>
                <a:pPr>
                  <a:tabLst>
                    <a:tab algn="l" pos="0"/>
                    <a:tab algn="l" pos="684360"/>
                    <a:tab algn="l" pos="1368360"/>
                    <a:tab algn="l" pos="2052720"/>
                    <a:tab algn="l" pos="2736720"/>
                    <a:tab algn="l" pos="3421080"/>
                    <a:tab algn="l" pos="4105440"/>
                    <a:tab algn="l" pos="4789440"/>
                    <a:tab algn="l" pos="5473800"/>
                    <a:tab algn="l" pos="6157800"/>
                    <a:tab algn="l" pos="6842160"/>
                    <a:tab algn="l" pos="7526160"/>
                    <a:tab algn="l" pos="8210520"/>
                    <a:tab algn="l" pos="8894880"/>
                    <a:tab algn="l" pos="9578880"/>
                    <a:tab algn="l" pos="10263240"/>
                    <a:tab algn="l" pos="10947240"/>
                  </a:tabLst>
                </a:pPr>
                <a:r>
                  <a:rPr b="1" lang="de-DE" sz="1200" spc="-1" strike="noStrike">
                    <a:solidFill>
                      <a:srgbClr val="000000"/>
                    </a:solidFill>
                    <a:latin typeface="Arial"/>
                  </a:rPr>
                  <a:t>+</a:t>
                </a:r>
                <a:endParaRPr b="1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44" name="Text Box 39"/>
            <p:cNvSpPr/>
            <p:nvPr/>
          </p:nvSpPr>
          <p:spPr>
            <a:xfrm rot="19239600">
              <a:off x="2690280" y="6017760"/>
              <a:ext cx="911160" cy="251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8400" rIns="68400" tIns="34200" bIns="34200" anchor="t">
              <a:spAutoFit/>
            </a:bodyPr>
            <a:p>
              <a:pPr>
                <a:tabLst>
                  <a:tab algn="l" pos="0"/>
                  <a:tab algn="l" pos="684360"/>
                  <a:tab algn="l" pos="1368360"/>
                  <a:tab algn="l" pos="2052720"/>
                  <a:tab algn="l" pos="2736720"/>
                  <a:tab algn="l" pos="3421080"/>
                  <a:tab algn="l" pos="4105440"/>
                  <a:tab algn="l" pos="4789440"/>
                  <a:tab algn="l" pos="5473800"/>
                  <a:tab algn="l" pos="6157800"/>
                  <a:tab algn="l" pos="6842160"/>
                  <a:tab algn="l" pos="7526160"/>
                  <a:tab algn="l" pos="8210520"/>
                  <a:tab algn="l" pos="8894880"/>
                  <a:tab algn="l" pos="9578880"/>
                  <a:tab algn="l" pos="10263240"/>
                  <a:tab algn="l" pos="1094724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</a:rPr>
                <a:t>sicontrol</a:t>
              </a: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5" name="Text Box 39"/>
            <p:cNvSpPr/>
            <p:nvPr/>
          </p:nvSpPr>
          <p:spPr>
            <a:xfrm rot="19224600">
              <a:off x="3315600" y="6004440"/>
              <a:ext cx="925200" cy="251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8400" rIns="68400" tIns="34200" bIns="34200" anchor="t">
              <a:spAutoFit/>
            </a:bodyPr>
            <a:p>
              <a:pPr>
                <a:tabLst>
                  <a:tab algn="l" pos="0"/>
                  <a:tab algn="l" pos="684360"/>
                  <a:tab algn="l" pos="1368360"/>
                  <a:tab algn="l" pos="2052720"/>
                  <a:tab algn="l" pos="2736720"/>
                  <a:tab algn="l" pos="3421080"/>
                  <a:tab algn="l" pos="4105440"/>
                  <a:tab algn="l" pos="4789440"/>
                  <a:tab algn="l" pos="5473800"/>
                  <a:tab algn="l" pos="6157800"/>
                  <a:tab algn="l" pos="6842160"/>
                  <a:tab algn="l" pos="7526160"/>
                  <a:tab algn="l" pos="8210520"/>
                  <a:tab algn="l" pos="8894880"/>
                  <a:tab algn="l" pos="9578880"/>
                  <a:tab algn="l" pos="10263240"/>
                  <a:tab algn="l" pos="1094724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</a:rPr>
                <a:t>siCasp-8</a:t>
              </a: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6" name="Line 288"/>
            <p:cNvSpPr/>
            <p:nvPr/>
          </p:nvSpPr>
          <p:spPr>
            <a:xfrm flipV="1">
              <a:off x="3223440" y="6485760"/>
              <a:ext cx="571680" cy="46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1" lang="en-US" sz="2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7" name="Line 288"/>
            <p:cNvSpPr/>
            <p:nvPr/>
          </p:nvSpPr>
          <p:spPr>
            <a:xfrm flipV="1">
              <a:off x="2591640" y="6485760"/>
              <a:ext cx="576000" cy="25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280" bIns="-44280" anchor="t">
              <a:noAutofit/>
            </a:bodyPr>
            <a:p>
              <a:endParaRPr b="1" lang="en-US" sz="2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8" name="Rectangle 299"/>
            <p:cNvSpPr/>
            <p:nvPr/>
          </p:nvSpPr>
          <p:spPr>
            <a:xfrm>
              <a:off x="2568600" y="7049160"/>
              <a:ext cx="1238400" cy="18504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2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49" name="Rectangle 443"/>
          <p:cNvSpPr/>
          <p:nvPr/>
        </p:nvSpPr>
        <p:spPr>
          <a:xfrm>
            <a:off x="3117960" y="2575080"/>
            <a:ext cx="93600" cy="9504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Rectangle 444"/>
          <p:cNvSpPr/>
          <p:nvPr/>
        </p:nvSpPr>
        <p:spPr>
          <a:xfrm>
            <a:off x="3122640" y="2743200"/>
            <a:ext cx="92160" cy="95400"/>
          </a:xfrm>
          <a:prstGeom prst="rect">
            <a:avLst/>
          </a:prstGeom>
          <a:solidFill>
            <a:srgbClr val="96969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1" name="Rectangle 445"/>
          <p:cNvSpPr/>
          <p:nvPr/>
        </p:nvSpPr>
        <p:spPr>
          <a:xfrm>
            <a:off x="3121200" y="2911320"/>
            <a:ext cx="90360" cy="9540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Text Box 446"/>
          <p:cNvSpPr/>
          <p:nvPr/>
        </p:nvSpPr>
        <p:spPr>
          <a:xfrm>
            <a:off x="3197160" y="2514600"/>
            <a:ext cx="1774800" cy="563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0200" rIns="70200" tIns="35280" bIns="3528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701640"/>
                <a:tab algn="l" pos="1403280"/>
                <a:tab algn="l" pos="2104920"/>
                <a:tab algn="l" pos="2806560"/>
                <a:tab algn="l" pos="3508200"/>
                <a:tab algn="l" pos="4210200"/>
                <a:tab algn="l" pos="4911840"/>
                <a:tab algn="l" pos="5613480"/>
                <a:tab algn="l" pos="6315120"/>
                <a:tab algn="l" pos="7016760"/>
                <a:tab algn="l" pos="7718400"/>
                <a:tab algn="l" pos="8420040"/>
                <a:tab algn="l" pos="9121680"/>
                <a:tab algn="l" pos="9823320"/>
                <a:tab algn="l" pos="1052496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TRAIL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701640"/>
                <a:tab algn="l" pos="1403280"/>
                <a:tab algn="l" pos="2104920"/>
                <a:tab algn="l" pos="2806560"/>
                <a:tab algn="l" pos="3508200"/>
                <a:tab algn="l" pos="4210200"/>
                <a:tab algn="l" pos="4911840"/>
                <a:tab algn="l" pos="5613480"/>
                <a:tab algn="l" pos="6315120"/>
                <a:tab algn="l" pos="7016760"/>
                <a:tab algn="l" pos="7718400"/>
                <a:tab algn="l" pos="8420040"/>
                <a:tab algn="l" pos="9121680"/>
                <a:tab algn="l" pos="9823320"/>
                <a:tab algn="l" pos="1052496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5-FU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701640"/>
                <a:tab algn="l" pos="1403280"/>
                <a:tab algn="l" pos="2104920"/>
                <a:tab algn="l" pos="2806560"/>
                <a:tab algn="l" pos="3508200"/>
                <a:tab algn="l" pos="4210200"/>
                <a:tab algn="l" pos="4911840"/>
                <a:tab algn="l" pos="5613480"/>
                <a:tab algn="l" pos="6315120"/>
                <a:tab algn="l" pos="7016760"/>
                <a:tab algn="l" pos="7718400"/>
                <a:tab algn="l" pos="8420040"/>
                <a:tab algn="l" pos="9121680"/>
                <a:tab algn="l" pos="9823320"/>
                <a:tab algn="l" pos="1052496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5-FU+TRAIL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Text Box 523"/>
          <p:cNvSpPr/>
          <p:nvPr/>
        </p:nvSpPr>
        <p:spPr>
          <a:xfrm rot="16200000">
            <a:off x="1172160" y="4248000"/>
            <a:ext cx="1753560" cy="253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70200" rIns="70200" tIns="35280" bIns="35280" anchor="t">
            <a:spAutoFit/>
          </a:bodyPr>
          <a:p>
            <a:pPr algn="ctr">
              <a:tabLst>
                <a:tab algn="l" pos="0"/>
                <a:tab algn="l" pos="701640"/>
                <a:tab algn="l" pos="1403280"/>
                <a:tab algn="l" pos="2104920"/>
                <a:tab algn="l" pos="2806560"/>
                <a:tab algn="l" pos="3508200"/>
                <a:tab algn="l" pos="4210200"/>
                <a:tab algn="l" pos="4911840"/>
                <a:tab algn="l" pos="5613480"/>
                <a:tab algn="l" pos="6315120"/>
                <a:tab algn="l" pos="7016760"/>
                <a:tab algn="l" pos="7718400"/>
                <a:tab algn="l" pos="8420040"/>
                <a:tab algn="l" pos="9121680"/>
                <a:tab algn="l" pos="9823320"/>
                <a:tab algn="l" pos="1052496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specific apoptosis (%)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Text Box 517"/>
          <p:cNvSpPr/>
          <p:nvPr/>
        </p:nvSpPr>
        <p:spPr>
          <a:xfrm>
            <a:off x="2817720" y="2924280"/>
            <a:ext cx="225360" cy="316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72720" rIns="72720" tIns="36360" bIns="36360" anchor="t">
            <a:spAutoFit/>
          </a:bodyPr>
          <a:p>
            <a:pPr>
              <a:tabLst>
                <a:tab algn="l" pos="0"/>
                <a:tab algn="l" pos="725400"/>
                <a:tab algn="l" pos="1450800"/>
                <a:tab algn="l" pos="2176560"/>
                <a:tab algn="l" pos="2901960"/>
                <a:tab algn="l" pos="3627360"/>
                <a:tab algn="l" pos="4352760"/>
                <a:tab algn="l" pos="5078520"/>
                <a:tab algn="l" pos="5803920"/>
                <a:tab algn="l" pos="6529320"/>
                <a:tab algn="l" pos="7254720"/>
                <a:tab algn="l" pos="7980480"/>
                <a:tab algn="l" pos="8705880"/>
                <a:tab algn="l" pos="9431280"/>
                <a:tab algn="l" pos="10156680"/>
                <a:tab algn="l" pos="10882440"/>
              </a:tabLst>
            </a:pPr>
            <a:r>
              <a:rPr b="1" lang="de-DE" sz="1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*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5" name="Text Box 524"/>
          <p:cNvSpPr/>
          <p:nvPr/>
        </p:nvSpPr>
        <p:spPr>
          <a:xfrm>
            <a:off x="2126880" y="3033720"/>
            <a:ext cx="311760" cy="262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70200" rIns="70200" tIns="35280" bIns="35280" anchor="t">
            <a:spAutoFit/>
          </a:bodyPr>
          <a:p>
            <a:pPr algn="r">
              <a:tabLst>
                <a:tab algn="l" pos="0"/>
                <a:tab algn="l" pos="701640"/>
                <a:tab algn="l" pos="1403280"/>
                <a:tab algn="l" pos="2104920"/>
                <a:tab algn="l" pos="2806560"/>
                <a:tab algn="l" pos="3508200"/>
                <a:tab algn="l" pos="4210200"/>
                <a:tab algn="l" pos="4911840"/>
                <a:tab algn="l" pos="5613480"/>
                <a:tab algn="l" pos="6315120"/>
                <a:tab algn="l" pos="7016760"/>
                <a:tab algn="l" pos="7718400"/>
                <a:tab algn="l" pos="8420040"/>
                <a:tab algn="l" pos="9121680"/>
                <a:tab algn="l" pos="9823320"/>
                <a:tab algn="l" pos="1052496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30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tabLst>
                <a:tab algn="l" pos="0"/>
                <a:tab algn="l" pos="701640"/>
                <a:tab algn="l" pos="1403280"/>
                <a:tab algn="l" pos="2104920"/>
                <a:tab algn="l" pos="2806560"/>
                <a:tab algn="l" pos="3508200"/>
                <a:tab algn="l" pos="4210200"/>
                <a:tab algn="l" pos="4911840"/>
                <a:tab algn="l" pos="5613480"/>
                <a:tab algn="l" pos="6315120"/>
                <a:tab algn="l" pos="7016760"/>
                <a:tab algn="l" pos="7718400"/>
                <a:tab algn="l" pos="8420040"/>
                <a:tab algn="l" pos="9121680"/>
                <a:tab algn="l" pos="9823320"/>
                <a:tab algn="l" pos="1052496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tabLst>
                <a:tab algn="l" pos="0"/>
                <a:tab algn="l" pos="701640"/>
                <a:tab algn="l" pos="1403280"/>
                <a:tab algn="l" pos="2104920"/>
                <a:tab algn="l" pos="2806560"/>
                <a:tab algn="l" pos="3508200"/>
                <a:tab algn="l" pos="4210200"/>
                <a:tab algn="l" pos="4911840"/>
                <a:tab algn="l" pos="5613480"/>
                <a:tab algn="l" pos="6315120"/>
                <a:tab algn="l" pos="7016760"/>
                <a:tab algn="l" pos="7718400"/>
                <a:tab algn="l" pos="8420040"/>
                <a:tab algn="l" pos="9121680"/>
                <a:tab algn="l" pos="9823320"/>
                <a:tab algn="l" pos="1052496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tabLst>
                <a:tab algn="l" pos="0"/>
                <a:tab algn="l" pos="701640"/>
                <a:tab algn="l" pos="1403280"/>
                <a:tab algn="l" pos="2104920"/>
                <a:tab algn="l" pos="2806560"/>
                <a:tab algn="l" pos="3508200"/>
                <a:tab algn="l" pos="4210200"/>
                <a:tab algn="l" pos="4911840"/>
                <a:tab algn="l" pos="5613480"/>
                <a:tab algn="l" pos="6315120"/>
                <a:tab algn="l" pos="7016760"/>
                <a:tab algn="l" pos="7718400"/>
                <a:tab algn="l" pos="8420040"/>
                <a:tab algn="l" pos="9121680"/>
                <a:tab algn="l" pos="9823320"/>
                <a:tab algn="l" pos="10524960"/>
              </a:tabLst>
            </a:pP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tabLst>
                <a:tab algn="l" pos="0"/>
                <a:tab algn="l" pos="701640"/>
                <a:tab algn="l" pos="1403280"/>
                <a:tab algn="l" pos="2104920"/>
                <a:tab algn="l" pos="2806560"/>
                <a:tab algn="l" pos="3508200"/>
                <a:tab algn="l" pos="4210200"/>
                <a:tab algn="l" pos="4911840"/>
                <a:tab algn="l" pos="5613480"/>
                <a:tab algn="l" pos="6315120"/>
                <a:tab algn="l" pos="7016760"/>
                <a:tab algn="l" pos="7718400"/>
                <a:tab algn="l" pos="8420040"/>
                <a:tab algn="l" pos="9121680"/>
                <a:tab algn="l" pos="9823320"/>
                <a:tab algn="l" pos="1052496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20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tabLst>
                <a:tab algn="l" pos="0"/>
                <a:tab algn="l" pos="701640"/>
                <a:tab algn="l" pos="1403280"/>
                <a:tab algn="l" pos="2104920"/>
                <a:tab algn="l" pos="2806560"/>
                <a:tab algn="l" pos="3508200"/>
                <a:tab algn="l" pos="4210200"/>
                <a:tab algn="l" pos="4911840"/>
                <a:tab algn="l" pos="5613480"/>
                <a:tab algn="l" pos="6315120"/>
                <a:tab algn="l" pos="7016760"/>
                <a:tab algn="l" pos="7718400"/>
                <a:tab algn="l" pos="8420040"/>
                <a:tab algn="l" pos="9121680"/>
                <a:tab algn="l" pos="9823320"/>
                <a:tab algn="l" pos="1052496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tabLst>
                <a:tab algn="l" pos="0"/>
                <a:tab algn="l" pos="701640"/>
                <a:tab algn="l" pos="1403280"/>
                <a:tab algn="l" pos="2104920"/>
                <a:tab algn="l" pos="2806560"/>
                <a:tab algn="l" pos="3508200"/>
                <a:tab algn="l" pos="4210200"/>
                <a:tab algn="l" pos="4911840"/>
                <a:tab algn="l" pos="5613480"/>
                <a:tab algn="l" pos="6315120"/>
                <a:tab algn="l" pos="7016760"/>
                <a:tab algn="l" pos="7718400"/>
                <a:tab algn="l" pos="8420040"/>
                <a:tab algn="l" pos="9121680"/>
                <a:tab algn="l" pos="9823320"/>
                <a:tab algn="l" pos="1052496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tabLst>
                <a:tab algn="l" pos="0"/>
                <a:tab algn="l" pos="701640"/>
                <a:tab algn="l" pos="1403280"/>
                <a:tab algn="l" pos="2104920"/>
                <a:tab algn="l" pos="2806560"/>
                <a:tab algn="l" pos="3508200"/>
                <a:tab algn="l" pos="4210200"/>
                <a:tab algn="l" pos="4911840"/>
                <a:tab algn="l" pos="5613480"/>
                <a:tab algn="l" pos="6315120"/>
                <a:tab algn="l" pos="7016760"/>
                <a:tab algn="l" pos="7718400"/>
                <a:tab algn="l" pos="8420040"/>
                <a:tab algn="l" pos="9121680"/>
                <a:tab algn="l" pos="9823320"/>
                <a:tab algn="l" pos="1052496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tabLst>
                <a:tab algn="l" pos="0"/>
                <a:tab algn="l" pos="701640"/>
                <a:tab algn="l" pos="1403280"/>
                <a:tab algn="l" pos="2104920"/>
                <a:tab algn="l" pos="2806560"/>
                <a:tab algn="l" pos="3508200"/>
                <a:tab algn="l" pos="4210200"/>
                <a:tab algn="l" pos="4911840"/>
                <a:tab algn="l" pos="5613480"/>
                <a:tab algn="l" pos="6315120"/>
                <a:tab algn="l" pos="7016760"/>
                <a:tab algn="l" pos="7718400"/>
                <a:tab algn="l" pos="8420040"/>
                <a:tab algn="l" pos="9121680"/>
                <a:tab algn="l" pos="9823320"/>
                <a:tab algn="l" pos="10524960"/>
              </a:tabLst>
            </a:pPr>
            <a:endParaRPr b="1" lang="en-US" sz="4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tabLst>
                <a:tab algn="l" pos="0"/>
                <a:tab algn="l" pos="701640"/>
                <a:tab algn="l" pos="1403280"/>
                <a:tab algn="l" pos="2104920"/>
                <a:tab algn="l" pos="2806560"/>
                <a:tab algn="l" pos="3508200"/>
                <a:tab algn="l" pos="4210200"/>
                <a:tab algn="l" pos="4911840"/>
                <a:tab algn="l" pos="5613480"/>
                <a:tab algn="l" pos="6315120"/>
                <a:tab algn="l" pos="7016760"/>
                <a:tab algn="l" pos="7718400"/>
                <a:tab algn="l" pos="8420040"/>
                <a:tab algn="l" pos="9121680"/>
                <a:tab algn="l" pos="9823320"/>
                <a:tab algn="l" pos="1052496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tabLst>
                <a:tab algn="l" pos="0"/>
                <a:tab algn="l" pos="701640"/>
                <a:tab algn="l" pos="1403280"/>
                <a:tab algn="l" pos="2104920"/>
                <a:tab algn="l" pos="2806560"/>
                <a:tab algn="l" pos="3508200"/>
                <a:tab algn="l" pos="4210200"/>
                <a:tab algn="l" pos="4911840"/>
                <a:tab algn="l" pos="5613480"/>
                <a:tab algn="l" pos="6315120"/>
                <a:tab algn="l" pos="7016760"/>
                <a:tab algn="l" pos="7718400"/>
                <a:tab algn="l" pos="8420040"/>
                <a:tab algn="l" pos="9121680"/>
                <a:tab algn="l" pos="9823320"/>
                <a:tab algn="l" pos="1052496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tabLst>
                <a:tab algn="l" pos="0"/>
                <a:tab algn="l" pos="701640"/>
                <a:tab algn="l" pos="1403280"/>
                <a:tab algn="l" pos="2104920"/>
                <a:tab algn="l" pos="2806560"/>
                <a:tab algn="l" pos="3508200"/>
                <a:tab algn="l" pos="4210200"/>
                <a:tab algn="l" pos="4911840"/>
                <a:tab algn="l" pos="5613480"/>
                <a:tab algn="l" pos="6315120"/>
                <a:tab algn="l" pos="7016760"/>
                <a:tab algn="l" pos="7718400"/>
                <a:tab algn="l" pos="8420040"/>
                <a:tab algn="l" pos="9121680"/>
                <a:tab algn="l" pos="9823320"/>
                <a:tab algn="l" pos="1052496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tabLst>
                <a:tab algn="l" pos="0"/>
                <a:tab algn="l" pos="701640"/>
                <a:tab algn="l" pos="1403280"/>
                <a:tab algn="l" pos="2104920"/>
                <a:tab algn="l" pos="2806560"/>
                <a:tab algn="l" pos="3508200"/>
                <a:tab algn="l" pos="4210200"/>
                <a:tab algn="l" pos="4911840"/>
                <a:tab algn="l" pos="5613480"/>
                <a:tab algn="l" pos="6315120"/>
                <a:tab algn="l" pos="7016760"/>
                <a:tab algn="l" pos="7718400"/>
                <a:tab algn="l" pos="8420040"/>
                <a:tab algn="l" pos="9121680"/>
                <a:tab algn="l" pos="9823320"/>
                <a:tab algn="l" pos="10524960"/>
              </a:tabLst>
            </a:pP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tabLst>
                <a:tab algn="l" pos="0"/>
                <a:tab algn="l" pos="701640"/>
                <a:tab algn="l" pos="1403280"/>
                <a:tab algn="l" pos="2104920"/>
                <a:tab algn="l" pos="2806560"/>
                <a:tab algn="l" pos="3508200"/>
                <a:tab algn="l" pos="4210200"/>
                <a:tab algn="l" pos="4911840"/>
                <a:tab algn="l" pos="5613480"/>
                <a:tab algn="l" pos="6315120"/>
                <a:tab algn="l" pos="7016760"/>
                <a:tab algn="l" pos="7718400"/>
                <a:tab algn="l" pos="8420040"/>
                <a:tab algn="l" pos="9121680"/>
                <a:tab algn="l" pos="9823320"/>
                <a:tab algn="l" pos="1052496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0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Text Box 448"/>
          <p:cNvSpPr/>
          <p:nvPr/>
        </p:nvSpPr>
        <p:spPr>
          <a:xfrm>
            <a:off x="2335320" y="5565600"/>
            <a:ext cx="1555920" cy="255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72720" rIns="72720" tIns="36360" bIns="36360" anchor="t">
            <a:spAutoFit/>
          </a:bodyPr>
          <a:p>
            <a:pPr>
              <a:tabLst>
                <a:tab algn="l" pos="0"/>
                <a:tab algn="l" pos="725400"/>
                <a:tab algn="l" pos="1450800"/>
                <a:tab algn="l" pos="2176560"/>
                <a:tab algn="l" pos="2901960"/>
                <a:tab algn="l" pos="3627360"/>
                <a:tab algn="l" pos="4352760"/>
                <a:tab algn="l" pos="5078520"/>
                <a:tab algn="l" pos="5803920"/>
                <a:tab algn="l" pos="6529320"/>
                <a:tab algn="l" pos="7254720"/>
                <a:tab algn="l" pos="7980480"/>
                <a:tab algn="l" pos="8705880"/>
                <a:tab algn="l" pos="9431280"/>
                <a:tab algn="l" pos="10156680"/>
                <a:tab algn="l" pos="1088244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 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sicontrol  siCasp-8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Text Box 521"/>
          <p:cNvSpPr/>
          <p:nvPr/>
        </p:nvSpPr>
        <p:spPr>
          <a:xfrm>
            <a:off x="3468600" y="4324320"/>
            <a:ext cx="403200" cy="240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2720" rIns="72720" tIns="36360" bIns="3636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725400"/>
                <a:tab algn="l" pos="1450800"/>
                <a:tab algn="l" pos="2176560"/>
                <a:tab algn="l" pos="2901960"/>
                <a:tab algn="l" pos="3627360"/>
                <a:tab algn="l" pos="4352760"/>
                <a:tab algn="l" pos="5078520"/>
                <a:tab algn="l" pos="5803920"/>
                <a:tab algn="l" pos="6529320"/>
                <a:tab algn="l" pos="7254720"/>
                <a:tab algn="l" pos="7980480"/>
                <a:tab algn="l" pos="8705880"/>
                <a:tab algn="l" pos="9431280"/>
                <a:tab algn="l" pos="10156680"/>
                <a:tab algn="l" pos="10882440"/>
              </a:tabLst>
            </a:pPr>
            <a:r>
              <a:rPr b="1" lang="de-DE" sz="11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NS</a:t>
            </a:r>
            <a:endParaRPr b="1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8" name="Textfeld 210"/>
          <p:cNvSpPr/>
          <p:nvPr/>
        </p:nvSpPr>
        <p:spPr>
          <a:xfrm>
            <a:off x="1892160" y="2763720"/>
            <a:ext cx="935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ALL-168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9" name="Gerade Verbindung 279"/>
          <p:cNvSpPr/>
          <p:nvPr/>
        </p:nvSpPr>
        <p:spPr>
          <a:xfrm>
            <a:off x="3191040" y="6802560"/>
            <a:ext cx="0" cy="18396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0" name="Gerade Verbindung 281"/>
          <p:cNvSpPr/>
          <p:nvPr/>
        </p:nvSpPr>
        <p:spPr>
          <a:xfrm>
            <a:off x="3189240" y="7050240"/>
            <a:ext cx="0" cy="18396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2-17T08:32:08Z</dcterms:created>
  <dc:creator>harald.ehrhardt</dc:creator>
  <dc:description/>
  <dc:language>en-US</dc:language>
  <cp:lastModifiedBy>haraldehrhardt</cp:lastModifiedBy>
  <dcterms:modified xsi:type="dcterms:W3CDTF">2012-02-22T12:31:31Z</dcterms:modified>
  <cp:revision>595</cp:revision>
  <dc:subject/>
  <dc:title>Folie 1</dc:title>
</cp:coreProperties>
</file>